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_rels/slide8.xml.rels" ContentType="application/vnd.openxmlformats-package.relationships+xml"/>
  <Override PartName="/ppt/slides/_rels/slide10.xml.rels" ContentType="application/vnd.openxmlformats-package.relationships+xml"/>
  <Override PartName="/ppt/slides/_rels/slide7.xml.rels" ContentType="application/vnd.openxmlformats-package.relationships+xml"/>
  <Override PartName="/ppt/slides/_rels/slide13.xml.rels" ContentType="application/vnd.openxmlformats-package.relationships+xml"/>
  <Override PartName="/ppt/slides/_rels/slide16.xml.rels" ContentType="application/vnd.openxmlformats-package.relationships+xml"/>
  <Override PartName="/ppt/slides/_rels/slide12.xml.rels" ContentType="application/vnd.openxmlformats-package.relationships+xml"/>
  <Override PartName="/ppt/slides/_rels/slide15.xml.rels" ContentType="application/vnd.openxmlformats-package.relationships+xml"/>
  <Override PartName="/ppt/slides/_rels/slide9.xml.rels" ContentType="application/vnd.openxmlformats-package.relationships+xml"/>
  <Override PartName="/ppt/slides/_rels/slide14.xml.rels" ContentType="application/vnd.openxmlformats-package.relationships+xml"/>
  <Override PartName="/ppt/slides/_rels/slide11.xml.rels" ContentType="application/vnd.openxmlformats-package.relationships+xml"/>
  <Override PartName="/ppt/slides/_rels/slide1.xml.rels" ContentType="application/vnd.openxmlformats-package.relationships+xml"/>
  <Override PartName="/ppt/slides/_rels/slide4.xml.rels" ContentType="application/vnd.openxmlformats-package.relationships+xml"/>
  <Override PartName="/ppt/slides/_rels/slide2.xml.rels" ContentType="application/vnd.openxmlformats-package.relationships+xml"/>
  <Override PartName="/ppt/slides/_rels/slide5.xml.rels" ContentType="application/vnd.openxmlformats-package.relationships+xml"/>
  <Override PartName="/ppt/slides/_rels/slide3.xml.rels" ContentType="application/vnd.openxmlformats-package.relationships+xml"/>
  <Override PartName="/ppt/slides/_rels/slide6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10.xml" ContentType="application/vnd.openxmlformats-officedocument.presentationml.slide+xml"/>
  <Override PartName="/ppt/slides/slide8.xml" ContentType="application/vnd.openxmlformats-officedocument.presentationml.slide+xml"/>
  <Override PartName="/ppt/slides/slide1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  <p:sldId id="269" r:id="rId17"/>
    <p:sldId id="270" r:id="rId18"/>
    <p:sldId id="271" r:id="rId19"/>
  </p:sldIdLst>
  <p:sldSz cx="9144000" cy="6858000"/>
  <p:notesSz cx="7077075" cy="90043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slide" Target="slides/slide13.xml"/><Relationship Id="rId17" Type="http://schemas.openxmlformats.org/officeDocument/2006/relationships/slide" Target="slides/slide14.xml"/><Relationship Id="rId18" Type="http://schemas.openxmlformats.org/officeDocument/2006/relationships/slide" Target="slides/slide15.xml"/><Relationship Id="rId19" Type="http://schemas.openxmlformats.org/officeDocument/2006/relationships/slide" Target="slides/slide16.xml"/><Relationship Id="rId20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0C3E61-21F0-4B74-BE60-F67D8E11DA8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169920" y="215640"/>
            <a:ext cx="8874000" cy="123804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LongIsland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/>
          </p:nvPr>
        </p:nvSpPr>
        <p:spPr>
          <a:xfrm>
            <a:off x="182160" y="1801800"/>
            <a:ext cx="8837640" cy="211716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/>
          </p:nvPr>
        </p:nvSpPr>
        <p:spPr>
          <a:xfrm>
            <a:off x="182160" y="4120560"/>
            <a:ext cx="8837640" cy="211716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FD0267-F048-4DC7-ACF3-866137176A9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169920" y="215640"/>
            <a:ext cx="8874000" cy="123804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LongIsland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182160" y="1801800"/>
            <a:ext cx="4312440" cy="211716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710600" y="1801800"/>
            <a:ext cx="4312440" cy="211716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182160" y="4120560"/>
            <a:ext cx="4312440" cy="211716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0600" y="4120560"/>
            <a:ext cx="4312440" cy="211716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84257A-4A4A-46DA-8573-672B7109427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PlaceHolder 1"/>
          <p:cNvSpPr>
            <a:spLocks noGrp="1"/>
          </p:cNvSpPr>
          <p:nvPr>
            <p:ph type="title"/>
          </p:nvPr>
        </p:nvSpPr>
        <p:spPr>
          <a:xfrm>
            <a:off x="169920" y="215640"/>
            <a:ext cx="8874000" cy="123804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LongIsland"/>
            </a:endParaRPr>
          </a:p>
        </p:txBody>
      </p:sp>
      <p:sp>
        <p:nvSpPr>
          <p:cNvPr id="40" name="PlaceHolder 2"/>
          <p:cNvSpPr>
            <a:spLocks noGrp="1"/>
          </p:cNvSpPr>
          <p:nvPr>
            <p:ph/>
          </p:nvPr>
        </p:nvSpPr>
        <p:spPr>
          <a:xfrm>
            <a:off x="182160" y="1801800"/>
            <a:ext cx="2845440" cy="211716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41" name="PlaceHolder 3"/>
          <p:cNvSpPr>
            <a:spLocks noGrp="1"/>
          </p:cNvSpPr>
          <p:nvPr>
            <p:ph/>
          </p:nvPr>
        </p:nvSpPr>
        <p:spPr>
          <a:xfrm>
            <a:off x="3170160" y="1801800"/>
            <a:ext cx="2845440" cy="211716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42" name="PlaceHolder 4"/>
          <p:cNvSpPr>
            <a:spLocks noGrp="1"/>
          </p:cNvSpPr>
          <p:nvPr>
            <p:ph/>
          </p:nvPr>
        </p:nvSpPr>
        <p:spPr>
          <a:xfrm>
            <a:off x="6158520" y="1801800"/>
            <a:ext cx="2845440" cy="211716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43" name="PlaceHolder 5"/>
          <p:cNvSpPr>
            <a:spLocks noGrp="1"/>
          </p:cNvSpPr>
          <p:nvPr>
            <p:ph/>
          </p:nvPr>
        </p:nvSpPr>
        <p:spPr>
          <a:xfrm>
            <a:off x="182160" y="4120560"/>
            <a:ext cx="2845440" cy="211716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44" name="PlaceHolder 6"/>
          <p:cNvSpPr>
            <a:spLocks noGrp="1"/>
          </p:cNvSpPr>
          <p:nvPr>
            <p:ph/>
          </p:nvPr>
        </p:nvSpPr>
        <p:spPr>
          <a:xfrm>
            <a:off x="3170160" y="4120560"/>
            <a:ext cx="2845440" cy="211716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45" name="PlaceHolder 7"/>
          <p:cNvSpPr>
            <a:spLocks noGrp="1"/>
          </p:cNvSpPr>
          <p:nvPr>
            <p:ph/>
          </p:nvPr>
        </p:nvSpPr>
        <p:spPr>
          <a:xfrm>
            <a:off x="6158520" y="4120560"/>
            <a:ext cx="2845440" cy="211716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44C660-042B-4104-BC7D-AA1F6B364D5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7CFFB3C-CE9A-4E61-BBD4-907601A959C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PlaceHolder 1"/>
          <p:cNvSpPr>
            <a:spLocks noGrp="1"/>
          </p:cNvSpPr>
          <p:nvPr>
            <p:ph type="title"/>
          </p:nvPr>
        </p:nvSpPr>
        <p:spPr>
          <a:xfrm>
            <a:off x="169920" y="215640"/>
            <a:ext cx="8874000" cy="123804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LongIsland"/>
            </a:endParaRPr>
          </a:p>
        </p:txBody>
      </p:sp>
      <p:sp>
        <p:nvSpPr>
          <p:cNvPr id="58" name="PlaceHolder 2"/>
          <p:cNvSpPr>
            <a:spLocks noGrp="1"/>
          </p:cNvSpPr>
          <p:nvPr>
            <p:ph type="subTitle"/>
          </p:nvPr>
        </p:nvSpPr>
        <p:spPr>
          <a:xfrm>
            <a:off x="182160" y="1801800"/>
            <a:ext cx="8837640" cy="4438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D697CE3-80B4-473E-93A2-D322ACCD135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169920" y="215640"/>
            <a:ext cx="8874000" cy="123804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LongIsland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182160" y="1801800"/>
            <a:ext cx="8837640" cy="443880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E4BAEC8-5B58-4E53-A27D-9E5DFE369F9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title"/>
          </p:nvPr>
        </p:nvSpPr>
        <p:spPr>
          <a:xfrm>
            <a:off x="169920" y="215640"/>
            <a:ext cx="8874000" cy="123804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LongIsland"/>
            </a:endParaRPr>
          </a:p>
        </p:txBody>
      </p:sp>
      <p:sp>
        <p:nvSpPr>
          <p:cNvPr id="62" name="PlaceHolder 2"/>
          <p:cNvSpPr>
            <a:spLocks noGrp="1"/>
          </p:cNvSpPr>
          <p:nvPr>
            <p:ph/>
          </p:nvPr>
        </p:nvSpPr>
        <p:spPr>
          <a:xfrm>
            <a:off x="182160" y="1801800"/>
            <a:ext cx="4312440" cy="443880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63" name="PlaceHolder 3"/>
          <p:cNvSpPr>
            <a:spLocks noGrp="1"/>
          </p:cNvSpPr>
          <p:nvPr>
            <p:ph/>
          </p:nvPr>
        </p:nvSpPr>
        <p:spPr>
          <a:xfrm>
            <a:off x="4710600" y="1801800"/>
            <a:ext cx="4312440" cy="443880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69EE7A2-84C6-4947-920B-57ABAB2EEAB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title"/>
          </p:nvPr>
        </p:nvSpPr>
        <p:spPr>
          <a:xfrm>
            <a:off x="169920" y="215640"/>
            <a:ext cx="8874000" cy="123804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LongIsland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9F7CC5A-88E2-417B-93AF-567773AA84A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PlaceHolder 1"/>
          <p:cNvSpPr>
            <a:spLocks noGrp="1"/>
          </p:cNvSpPr>
          <p:nvPr>
            <p:ph type="subTitle"/>
          </p:nvPr>
        </p:nvSpPr>
        <p:spPr>
          <a:xfrm>
            <a:off x="169920" y="215640"/>
            <a:ext cx="8874000" cy="5740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E965F34-5708-4589-A837-9693EF98F81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PlaceHolder 1"/>
          <p:cNvSpPr>
            <a:spLocks noGrp="1"/>
          </p:cNvSpPr>
          <p:nvPr>
            <p:ph type="title"/>
          </p:nvPr>
        </p:nvSpPr>
        <p:spPr>
          <a:xfrm>
            <a:off x="169920" y="215640"/>
            <a:ext cx="8874000" cy="123804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LongIsland"/>
            </a:endParaRPr>
          </a:p>
        </p:txBody>
      </p:sp>
      <p:sp>
        <p:nvSpPr>
          <p:cNvPr id="67" name="PlaceHolder 2"/>
          <p:cNvSpPr>
            <a:spLocks noGrp="1"/>
          </p:cNvSpPr>
          <p:nvPr>
            <p:ph/>
          </p:nvPr>
        </p:nvSpPr>
        <p:spPr>
          <a:xfrm>
            <a:off x="182160" y="1801800"/>
            <a:ext cx="4312440" cy="211716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68" name="PlaceHolder 3"/>
          <p:cNvSpPr>
            <a:spLocks noGrp="1"/>
          </p:cNvSpPr>
          <p:nvPr>
            <p:ph/>
          </p:nvPr>
        </p:nvSpPr>
        <p:spPr>
          <a:xfrm>
            <a:off x="4710600" y="1801800"/>
            <a:ext cx="4312440" cy="443880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69" name="PlaceHolder 4"/>
          <p:cNvSpPr>
            <a:spLocks noGrp="1"/>
          </p:cNvSpPr>
          <p:nvPr>
            <p:ph/>
          </p:nvPr>
        </p:nvSpPr>
        <p:spPr>
          <a:xfrm>
            <a:off x="182160" y="4120560"/>
            <a:ext cx="4312440" cy="211716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6CC08E4-B339-44B6-9ED9-D2538CCBDB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169920" y="215640"/>
            <a:ext cx="8874000" cy="123804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LongIsland"/>
            </a:endParaRPr>
          </a:p>
        </p:txBody>
      </p:sp>
      <p:sp>
        <p:nvSpPr>
          <p:cNvPr id="11" name="PlaceHolder 2"/>
          <p:cNvSpPr>
            <a:spLocks noGrp="1"/>
          </p:cNvSpPr>
          <p:nvPr>
            <p:ph type="subTitle"/>
          </p:nvPr>
        </p:nvSpPr>
        <p:spPr>
          <a:xfrm>
            <a:off x="182160" y="1801800"/>
            <a:ext cx="8837640" cy="4438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9A2937-1683-445B-8433-3E9785349D7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169920" y="215640"/>
            <a:ext cx="8874000" cy="123804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LongIsland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182160" y="1801800"/>
            <a:ext cx="4312440" cy="443880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710600" y="1801800"/>
            <a:ext cx="4312440" cy="211716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4710600" y="4120560"/>
            <a:ext cx="4312440" cy="211716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4AF21B1-5CAC-4AF7-8F58-2F4FD142BC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PlaceHolder 1"/>
          <p:cNvSpPr>
            <a:spLocks noGrp="1"/>
          </p:cNvSpPr>
          <p:nvPr>
            <p:ph type="title"/>
          </p:nvPr>
        </p:nvSpPr>
        <p:spPr>
          <a:xfrm>
            <a:off x="169920" y="215640"/>
            <a:ext cx="8874000" cy="123804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LongIsland"/>
            </a:endParaRPr>
          </a:p>
        </p:txBody>
      </p:sp>
      <p:sp>
        <p:nvSpPr>
          <p:cNvPr id="75" name="PlaceHolder 2"/>
          <p:cNvSpPr>
            <a:spLocks noGrp="1"/>
          </p:cNvSpPr>
          <p:nvPr>
            <p:ph/>
          </p:nvPr>
        </p:nvSpPr>
        <p:spPr>
          <a:xfrm>
            <a:off x="182160" y="1801800"/>
            <a:ext cx="4312440" cy="211716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76" name="PlaceHolder 3"/>
          <p:cNvSpPr>
            <a:spLocks noGrp="1"/>
          </p:cNvSpPr>
          <p:nvPr>
            <p:ph/>
          </p:nvPr>
        </p:nvSpPr>
        <p:spPr>
          <a:xfrm>
            <a:off x="4710600" y="1801800"/>
            <a:ext cx="4312440" cy="211716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77" name="PlaceHolder 4"/>
          <p:cNvSpPr>
            <a:spLocks noGrp="1"/>
          </p:cNvSpPr>
          <p:nvPr>
            <p:ph/>
          </p:nvPr>
        </p:nvSpPr>
        <p:spPr>
          <a:xfrm>
            <a:off x="182160" y="4120560"/>
            <a:ext cx="8837640" cy="211716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C2D0D3C-88AE-43C9-91F1-C30B277FB5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PlaceHolder 1"/>
          <p:cNvSpPr>
            <a:spLocks noGrp="1"/>
          </p:cNvSpPr>
          <p:nvPr>
            <p:ph type="title"/>
          </p:nvPr>
        </p:nvSpPr>
        <p:spPr>
          <a:xfrm>
            <a:off x="169920" y="215640"/>
            <a:ext cx="8874000" cy="123804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LongIsland"/>
            </a:endParaRPr>
          </a:p>
        </p:txBody>
      </p:sp>
      <p:sp>
        <p:nvSpPr>
          <p:cNvPr id="79" name="PlaceHolder 2"/>
          <p:cNvSpPr>
            <a:spLocks noGrp="1"/>
          </p:cNvSpPr>
          <p:nvPr>
            <p:ph/>
          </p:nvPr>
        </p:nvSpPr>
        <p:spPr>
          <a:xfrm>
            <a:off x="182160" y="1801800"/>
            <a:ext cx="8837640" cy="211716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80" name="PlaceHolder 3"/>
          <p:cNvSpPr>
            <a:spLocks noGrp="1"/>
          </p:cNvSpPr>
          <p:nvPr>
            <p:ph/>
          </p:nvPr>
        </p:nvSpPr>
        <p:spPr>
          <a:xfrm>
            <a:off x="182160" y="4120560"/>
            <a:ext cx="8837640" cy="211716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D3A0CF8-FFBB-49A5-87F2-2550BFD5161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PlaceHolder 1"/>
          <p:cNvSpPr>
            <a:spLocks noGrp="1"/>
          </p:cNvSpPr>
          <p:nvPr>
            <p:ph type="title"/>
          </p:nvPr>
        </p:nvSpPr>
        <p:spPr>
          <a:xfrm>
            <a:off x="169920" y="215640"/>
            <a:ext cx="8874000" cy="123804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LongIsland"/>
            </a:endParaRPr>
          </a:p>
        </p:txBody>
      </p:sp>
      <p:sp>
        <p:nvSpPr>
          <p:cNvPr id="82" name="PlaceHolder 2"/>
          <p:cNvSpPr>
            <a:spLocks noGrp="1"/>
          </p:cNvSpPr>
          <p:nvPr>
            <p:ph/>
          </p:nvPr>
        </p:nvSpPr>
        <p:spPr>
          <a:xfrm>
            <a:off x="182160" y="1801800"/>
            <a:ext cx="4312440" cy="211716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83" name="PlaceHolder 3"/>
          <p:cNvSpPr>
            <a:spLocks noGrp="1"/>
          </p:cNvSpPr>
          <p:nvPr>
            <p:ph/>
          </p:nvPr>
        </p:nvSpPr>
        <p:spPr>
          <a:xfrm>
            <a:off x="4710600" y="1801800"/>
            <a:ext cx="4312440" cy="211716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84" name="PlaceHolder 4"/>
          <p:cNvSpPr>
            <a:spLocks noGrp="1"/>
          </p:cNvSpPr>
          <p:nvPr>
            <p:ph/>
          </p:nvPr>
        </p:nvSpPr>
        <p:spPr>
          <a:xfrm>
            <a:off x="182160" y="4120560"/>
            <a:ext cx="4312440" cy="211716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85" name="PlaceHolder 5"/>
          <p:cNvSpPr>
            <a:spLocks noGrp="1"/>
          </p:cNvSpPr>
          <p:nvPr>
            <p:ph/>
          </p:nvPr>
        </p:nvSpPr>
        <p:spPr>
          <a:xfrm>
            <a:off x="4710600" y="4120560"/>
            <a:ext cx="4312440" cy="211716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C8E2CC5-E235-465C-B1EE-9DAB9184DAB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PlaceHolder 1"/>
          <p:cNvSpPr>
            <a:spLocks noGrp="1"/>
          </p:cNvSpPr>
          <p:nvPr>
            <p:ph type="title"/>
          </p:nvPr>
        </p:nvSpPr>
        <p:spPr>
          <a:xfrm>
            <a:off x="169920" y="215640"/>
            <a:ext cx="8874000" cy="123804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LongIsland"/>
            </a:endParaRPr>
          </a:p>
        </p:txBody>
      </p:sp>
      <p:sp>
        <p:nvSpPr>
          <p:cNvPr id="87" name="PlaceHolder 2"/>
          <p:cNvSpPr>
            <a:spLocks noGrp="1"/>
          </p:cNvSpPr>
          <p:nvPr>
            <p:ph/>
          </p:nvPr>
        </p:nvSpPr>
        <p:spPr>
          <a:xfrm>
            <a:off x="182160" y="1801800"/>
            <a:ext cx="2845440" cy="211716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88" name="PlaceHolder 3"/>
          <p:cNvSpPr>
            <a:spLocks noGrp="1"/>
          </p:cNvSpPr>
          <p:nvPr>
            <p:ph/>
          </p:nvPr>
        </p:nvSpPr>
        <p:spPr>
          <a:xfrm>
            <a:off x="3170160" y="1801800"/>
            <a:ext cx="2845440" cy="211716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89" name="PlaceHolder 4"/>
          <p:cNvSpPr>
            <a:spLocks noGrp="1"/>
          </p:cNvSpPr>
          <p:nvPr>
            <p:ph/>
          </p:nvPr>
        </p:nvSpPr>
        <p:spPr>
          <a:xfrm>
            <a:off x="6158520" y="1801800"/>
            <a:ext cx="2845440" cy="211716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90" name="PlaceHolder 5"/>
          <p:cNvSpPr>
            <a:spLocks noGrp="1"/>
          </p:cNvSpPr>
          <p:nvPr>
            <p:ph/>
          </p:nvPr>
        </p:nvSpPr>
        <p:spPr>
          <a:xfrm>
            <a:off x="182160" y="4120560"/>
            <a:ext cx="2845440" cy="211716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91" name="PlaceHolder 6"/>
          <p:cNvSpPr>
            <a:spLocks noGrp="1"/>
          </p:cNvSpPr>
          <p:nvPr>
            <p:ph/>
          </p:nvPr>
        </p:nvSpPr>
        <p:spPr>
          <a:xfrm>
            <a:off x="3170160" y="4120560"/>
            <a:ext cx="2845440" cy="211716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92" name="PlaceHolder 7"/>
          <p:cNvSpPr>
            <a:spLocks noGrp="1"/>
          </p:cNvSpPr>
          <p:nvPr>
            <p:ph/>
          </p:nvPr>
        </p:nvSpPr>
        <p:spPr>
          <a:xfrm>
            <a:off x="6158520" y="4120560"/>
            <a:ext cx="2845440" cy="211716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0D5330B-B0E3-4171-AF04-5555F7F2834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169920" y="215640"/>
            <a:ext cx="8874000" cy="123804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LongIsland"/>
            </a:endParaRPr>
          </a:p>
        </p:txBody>
      </p:sp>
      <p:sp>
        <p:nvSpPr>
          <p:cNvPr id="13" name="PlaceHolder 2"/>
          <p:cNvSpPr>
            <a:spLocks noGrp="1"/>
          </p:cNvSpPr>
          <p:nvPr>
            <p:ph/>
          </p:nvPr>
        </p:nvSpPr>
        <p:spPr>
          <a:xfrm>
            <a:off x="182160" y="1801800"/>
            <a:ext cx="8837640" cy="443880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76FF6A-8894-4029-A9F1-CD612D958D9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169920" y="215640"/>
            <a:ext cx="8874000" cy="123804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LongIsland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182160" y="1801800"/>
            <a:ext cx="4312440" cy="443880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710600" y="1801800"/>
            <a:ext cx="4312440" cy="443880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A6F1FF-D94A-4AAB-973B-B28E9D5811A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PlaceHolder 1"/>
          <p:cNvSpPr>
            <a:spLocks noGrp="1"/>
          </p:cNvSpPr>
          <p:nvPr>
            <p:ph type="title"/>
          </p:nvPr>
        </p:nvSpPr>
        <p:spPr>
          <a:xfrm>
            <a:off x="169920" y="215640"/>
            <a:ext cx="8874000" cy="123804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LongIsland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A7FE76-B7CB-4494-AF72-88647C020CA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subTitle"/>
          </p:nvPr>
        </p:nvSpPr>
        <p:spPr>
          <a:xfrm>
            <a:off x="169920" y="215640"/>
            <a:ext cx="8874000" cy="5740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EB1ED0-89C3-4F01-8D90-797A070E12C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169920" y="215640"/>
            <a:ext cx="8874000" cy="123804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LongIsland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/>
          </p:nvPr>
        </p:nvSpPr>
        <p:spPr>
          <a:xfrm>
            <a:off x="182160" y="1801800"/>
            <a:ext cx="4312440" cy="211716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/>
          </p:nvPr>
        </p:nvSpPr>
        <p:spPr>
          <a:xfrm>
            <a:off x="4710600" y="1801800"/>
            <a:ext cx="4312440" cy="443880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/>
          </p:nvPr>
        </p:nvSpPr>
        <p:spPr>
          <a:xfrm>
            <a:off x="182160" y="4120560"/>
            <a:ext cx="4312440" cy="211716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CC8242-7F9A-47B4-BD0C-37420898A9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169920" y="215640"/>
            <a:ext cx="8874000" cy="123804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LongIsland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/>
          </p:nvPr>
        </p:nvSpPr>
        <p:spPr>
          <a:xfrm>
            <a:off x="182160" y="1801800"/>
            <a:ext cx="4312440" cy="443880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/>
          </p:nvPr>
        </p:nvSpPr>
        <p:spPr>
          <a:xfrm>
            <a:off x="4710600" y="1801800"/>
            <a:ext cx="4312440" cy="211716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26" name="PlaceHolder 4"/>
          <p:cNvSpPr>
            <a:spLocks noGrp="1"/>
          </p:cNvSpPr>
          <p:nvPr>
            <p:ph/>
          </p:nvPr>
        </p:nvSpPr>
        <p:spPr>
          <a:xfrm>
            <a:off x="4710600" y="4120560"/>
            <a:ext cx="4312440" cy="211716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82E876-6480-4F47-A355-0CFC820344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PlaceHolder 1"/>
          <p:cNvSpPr>
            <a:spLocks noGrp="1"/>
          </p:cNvSpPr>
          <p:nvPr>
            <p:ph type="title"/>
          </p:nvPr>
        </p:nvSpPr>
        <p:spPr>
          <a:xfrm>
            <a:off x="169920" y="215640"/>
            <a:ext cx="8874000" cy="123804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LongIsland"/>
            </a:endParaRPr>
          </a:p>
        </p:txBody>
      </p:sp>
      <p:sp>
        <p:nvSpPr>
          <p:cNvPr id="28" name="PlaceHolder 2"/>
          <p:cNvSpPr>
            <a:spLocks noGrp="1"/>
          </p:cNvSpPr>
          <p:nvPr>
            <p:ph/>
          </p:nvPr>
        </p:nvSpPr>
        <p:spPr>
          <a:xfrm>
            <a:off x="182160" y="1801800"/>
            <a:ext cx="4312440" cy="211716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29" name="PlaceHolder 3"/>
          <p:cNvSpPr>
            <a:spLocks noGrp="1"/>
          </p:cNvSpPr>
          <p:nvPr>
            <p:ph/>
          </p:nvPr>
        </p:nvSpPr>
        <p:spPr>
          <a:xfrm>
            <a:off x="4710600" y="1801800"/>
            <a:ext cx="4312440" cy="211716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30" name="PlaceHolder 4"/>
          <p:cNvSpPr>
            <a:spLocks noGrp="1"/>
          </p:cNvSpPr>
          <p:nvPr>
            <p:ph/>
          </p:nvPr>
        </p:nvSpPr>
        <p:spPr>
          <a:xfrm>
            <a:off x="182160" y="4120560"/>
            <a:ext cx="8837640" cy="211716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6F9FF7-E381-4412-9413-4D129E5B56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8080"/>
            </a:gs>
            <a:gs pos="100000">
              <a:srgbClr val="003b3b"/>
            </a:gs>
          </a:gsLst>
          <a:lin ang="135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169920" y="215640"/>
            <a:ext cx="8874000" cy="123804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ccecff"/>
                </a:solidFill>
                <a:latin typeface="LongIsland"/>
              </a:rPr>
              <a:t>Click to edit the title text format</a:t>
            </a:r>
            <a:endParaRPr b="0" lang="en-US" sz="4400" spc="-1" strike="noStrike">
              <a:solidFill>
                <a:srgbClr val="ccecff"/>
              </a:solidFill>
              <a:latin typeface="LongIsland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182160" y="1801800"/>
            <a:ext cx="8837640" cy="443880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marL="343080" indent="-343080">
              <a:spcBef>
                <a:spcPts val="799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cc"/>
                </a:solidFill>
                <a:latin typeface="LongIsland"/>
              </a:rPr>
              <a:t>Click to edit the outline text format</a:t>
            </a: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  <a:p>
            <a:pPr lvl="1" marL="743040" indent="-285840">
              <a:spcBef>
                <a:spcPts val="799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cc"/>
                </a:solidFill>
                <a:latin typeface="LongIsland"/>
              </a:rPr>
              <a:t>Second Outline Level</a:t>
            </a: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  <a:p>
            <a:pPr lvl="2" marL="1143000" indent="-228600">
              <a:spcBef>
                <a:spcPts val="799"/>
              </a:spcBef>
              <a:buClr>
                <a:srgbClr val="00cccc"/>
              </a:buClr>
              <a:buSzPct val="75000"/>
              <a:buFont typeface="LongIsland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cc"/>
                </a:solidFill>
                <a:latin typeface="LongIsland"/>
              </a:rPr>
              <a:t>Third Outline Level</a:t>
            </a: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  <a:p>
            <a:pPr lvl="3" marL="1600200" indent="-228600">
              <a:spcBef>
                <a:spcPts val="799"/>
              </a:spcBef>
              <a:buClr>
                <a:srgbClr val="cc00cc"/>
              </a:buClr>
              <a:buSzPct val="75000"/>
              <a:buFont typeface="LongIsland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cc"/>
                </a:solidFill>
                <a:latin typeface="LongIsland"/>
              </a:rPr>
              <a:t>Fourth Outline Level</a:t>
            </a: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  <a:p>
            <a:pPr lvl="4" marL="2057400" indent="-228600">
              <a:spcBef>
                <a:spcPts val="799"/>
              </a:spcBef>
              <a:buClr>
                <a:srgbClr val="b2b2b2"/>
              </a:buClr>
              <a:buSzPct val="75000"/>
              <a:buFont typeface="LongIsland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cc"/>
                </a:solidFill>
                <a:latin typeface="LongIsland"/>
              </a:rPr>
              <a:t>Fifth Outline Level</a:t>
            </a: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  <a:p>
            <a:pPr lvl="5" marL="2057400" indent="-228600">
              <a:spcBef>
                <a:spcPts val="799"/>
              </a:spcBef>
              <a:buClr>
                <a:srgbClr val="ffffcc"/>
              </a:buClr>
              <a:buSzPct val="75000"/>
              <a:buFont typeface="LongIsland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cc"/>
                </a:solidFill>
                <a:latin typeface="LongIsland"/>
              </a:rPr>
              <a:t>Sixth Outline Level</a:t>
            </a: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  <a:p>
            <a:pPr lvl="6" marL="2057400" indent="-228600">
              <a:spcBef>
                <a:spcPts val="799"/>
              </a:spcBef>
              <a:buClr>
                <a:srgbClr val="ffffcc"/>
              </a:buClr>
              <a:buSzPct val="75000"/>
              <a:buFont typeface="LongIsland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cc"/>
                </a:solidFill>
                <a:latin typeface="LongIsland"/>
              </a:rPr>
              <a:t>Seventh Outline Level</a:t>
            </a: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182520" y="6342120"/>
            <a:ext cx="2635200" cy="45720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cc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922120" y="6342120"/>
            <a:ext cx="3449880" cy="45720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cc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77120" y="6342120"/>
            <a:ext cx="2519280" cy="45720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cc"/>
              </a:solidFill>
              <a:latin typeface="Times New Roman"/>
            </a:endParaRPr>
          </a:p>
        </p:txBody>
      </p:sp>
      <p:sp>
        <p:nvSpPr>
          <p:cNvPr id="5" name=""/>
          <p:cNvSpPr/>
          <p:nvPr/>
        </p:nvSpPr>
        <p:spPr>
          <a:xfrm>
            <a:off x="0" y="1523880"/>
            <a:ext cx="9142560" cy="209520"/>
          </a:xfrm>
          <a:prstGeom prst="rect">
            <a:avLst/>
          </a:prstGeom>
          <a:gradFill rotWithShape="0">
            <a:gsLst>
              <a:gs pos="0">
                <a:srgbClr val="006666"/>
              </a:gs>
              <a:gs pos="100000">
                <a:srgbClr val="008080"/>
              </a:gs>
            </a:gsLst>
            <a:lin ang="108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ffffcc"/>
              </a:solidFill>
              <a:latin typeface="Times New Roman"/>
            </a:endParaRPr>
          </a:p>
        </p:txBody>
      </p:sp>
      <p:grpSp>
        <p:nvGrpSpPr>
          <p:cNvPr id="6" name=""/>
          <p:cNvGrpSpPr/>
          <p:nvPr/>
        </p:nvGrpSpPr>
        <p:grpSpPr>
          <a:xfrm>
            <a:off x="0" y="1585800"/>
            <a:ext cx="9142560" cy="101880"/>
            <a:chOff x="0" y="1585800"/>
            <a:chExt cx="9142560" cy="101880"/>
          </a:xfrm>
        </p:grpSpPr>
        <p:sp>
          <p:nvSpPr>
            <p:cNvPr id="7" name=""/>
            <p:cNvSpPr/>
            <p:nvPr/>
          </p:nvSpPr>
          <p:spPr>
            <a:xfrm>
              <a:off x="6094440" y="1585800"/>
              <a:ext cx="3048120" cy="101880"/>
            </a:xfrm>
            <a:prstGeom prst="rect">
              <a:avLst/>
            </a:prstGeom>
            <a:gradFill rotWithShape="0">
              <a:gsLst>
                <a:gs pos="0">
                  <a:srgbClr val="000000"/>
                </a:gs>
                <a:gs pos="50000">
                  <a:srgbClr val="00cccc"/>
                </a:gs>
                <a:gs pos="100000">
                  <a:srgbClr val="000000"/>
                </a:gs>
              </a:gsLst>
              <a:lin ang="108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ffffcc"/>
                </a:solidFill>
                <a:latin typeface="Times New Roman"/>
              </a:endParaRPr>
            </a:p>
          </p:txBody>
        </p:sp>
        <p:sp>
          <p:nvSpPr>
            <p:cNvPr id="8" name=""/>
            <p:cNvSpPr/>
            <p:nvPr/>
          </p:nvSpPr>
          <p:spPr>
            <a:xfrm>
              <a:off x="0" y="1585800"/>
              <a:ext cx="3048120" cy="101880"/>
            </a:xfrm>
            <a:prstGeom prst="rect">
              <a:avLst/>
            </a:prstGeom>
            <a:gradFill rotWithShape="0">
              <a:gsLst>
                <a:gs pos="0">
                  <a:srgbClr val="000000"/>
                </a:gs>
                <a:gs pos="50000">
                  <a:srgbClr val="cc00cc"/>
                </a:gs>
                <a:gs pos="100000">
                  <a:srgbClr val="000000"/>
                </a:gs>
              </a:gsLst>
              <a:lin ang="108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ffffcc"/>
                </a:solidFill>
                <a:latin typeface="Times New Roman"/>
              </a:endParaRPr>
            </a:p>
          </p:txBody>
        </p:sp>
        <p:sp>
          <p:nvSpPr>
            <p:cNvPr id="9" name=""/>
            <p:cNvSpPr/>
            <p:nvPr/>
          </p:nvSpPr>
          <p:spPr>
            <a:xfrm>
              <a:off x="3048120" y="1585800"/>
              <a:ext cx="3046320" cy="101880"/>
            </a:xfrm>
            <a:prstGeom prst="rect">
              <a:avLst/>
            </a:prstGeom>
            <a:gradFill rotWithShape="0">
              <a:gsLst>
                <a:gs pos="0">
                  <a:srgbClr val="000000"/>
                </a:gs>
                <a:gs pos="50000">
                  <a:srgbClr val="b2b2b2"/>
                </a:gs>
                <a:gs pos="100000">
                  <a:srgbClr val="000000"/>
                </a:gs>
              </a:gsLst>
              <a:lin ang="108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ffffcc"/>
                </a:solidFill>
                <a:latin typeface="Times New Roman"/>
              </a:endParaRPr>
            </a:p>
          </p:txBody>
        </p:sp>
      </p:grp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8080"/>
            </a:gs>
            <a:gs pos="100000">
              <a:srgbClr val="003b3b"/>
            </a:gs>
          </a:gsLst>
          <a:lin ang="135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6" name=""/>
          <p:cNvGrpSpPr/>
          <p:nvPr/>
        </p:nvGrpSpPr>
        <p:grpSpPr>
          <a:xfrm>
            <a:off x="0" y="58680"/>
            <a:ext cx="9142560" cy="1709640"/>
            <a:chOff x="0" y="58680"/>
            <a:chExt cx="9142560" cy="1709640"/>
          </a:xfrm>
        </p:grpSpPr>
        <p:sp>
          <p:nvSpPr>
            <p:cNvPr id="47" name=""/>
            <p:cNvSpPr/>
            <p:nvPr/>
          </p:nvSpPr>
          <p:spPr>
            <a:xfrm>
              <a:off x="6093000" y="58680"/>
              <a:ext cx="3049560" cy="1709640"/>
            </a:xfrm>
            <a:prstGeom prst="rect">
              <a:avLst/>
            </a:prstGeom>
            <a:gradFill rotWithShape="0">
              <a:gsLst>
                <a:gs pos="0">
                  <a:srgbClr val="000000"/>
                </a:gs>
                <a:gs pos="50000">
                  <a:srgbClr val="00cccc"/>
                </a:gs>
                <a:gs pos="100000">
                  <a:srgbClr val="000000"/>
                </a:gs>
              </a:gsLst>
              <a:lin ang="108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ffffcc"/>
                </a:solidFill>
                <a:latin typeface="Times New Roman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0" y="58680"/>
              <a:ext cx="3049560" cy="1709640"/>
            </a:xfrm>
            <a:prstGeom prst="rect">
              <a:avLst/>
            </a:prstGeom>
            <a:gradFill rotWithShape="0">
              <a:gsLst>
                <a:gs pos="0">
                  <a:srgbClr val="000000"/>
                </a:gs>
                <a:gs pos="50000">
                  <a:srgbClr val="cc00cc"/>
                </a:gs>
                <a:gs pos="100000">
                  <a:srgbClr val="000000"/>
                </a:gs>
              </a:gsLst>
              <a:lin ang="108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ffffcc"/>
                </a:solidFill>
                <a:latin typeface="Times New Roman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3049560" y="58680"/>
              <a:ext cx="3043440" cy="1709640"/>
            </a:xfrm>
            <a:prstGeom prst="rect">
              <a:avLst/>
            </a:prstGeom>
            <a:gradFill rotWithShape="0">
              <a:gsLst>
                <a:gs pos="0">
                  <a:srgbClr val="000000"/>
                </a:gs>
                <a:gs pos="50000">
                  <a:srgbClr val="b2b2b2"/>
                </a:gs>
                <a:gs pos="100000">
                  <a:srgbClr val="000000"/>
                </a:gs>
              </a:gsLst>
              <a:lin ang="108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ffffcc"/>
                </a:solidFill>
                <a:latin typeface="Times New Roman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0" y="1665360"/>
              <a:ext cx="9142560" cy="65160"/>
            </a:xfrm>
            <a:prstGeom prst="rect">
              <a:avLst/>
            </a:prstGeom>
            <a:gradFill rotWithShape="0">
              <a:gsLst>
                <a:gs pos="0">
                  <a:srgbClr val="006666"/>
                </a:gs>
                <a:gs pos="100000">
                  <a:srgbClr val="008080"/>
                </a:gs>
              </a:gsLst>
              <a:lin ang="108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endParaRPr b="0" lang="en-US" sz="2400" spc="-1" strike="noStrike">
                <a:solidFill>
                  <a:srgbClr val="ffffcc"/>
                </a:solidFill>
                <a:latin typeface="Times New Roman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0" y="100080"/>
              <a:ext cx="9142560" cy="61920"/>
            </a:xfrm>
            <a:prstGeom prst="rect">
              <a:avLst/>
            </a:prstGeom>
            <a:gradFill rotWithShape="0">
              <a:gsLst>
                <a:gs pos="0">
                  <a:srgbClr val="006666"/>
                </a:gs>
                <a:gs pos="100000">
                  <a:srgbClr val="008080"/>
                </a:gs>
              </a:gsLst>
              <a:lin ang="108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2400" spc="-1" strike="noStrike">
                <a:solidFill>
                  <a:srgbClr val="ffffcc"/>
                </a:solidFill>
                <a:latin typeface="Times New Roman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0" y="366840"/>
              <a:ext cx="9142560" cy="1076040"/>
            </a:xfrm>
            <a:prstGeom prst="rect">
              <a:avLst/>
            </a:prstGeom>
            <a:gradFill rotWithShape="0">
              <a:gsLst>
                <a:gs pos="0">
                  <a:srgbClr val="008080"/>
                </a:gs>
                <a:gs pos="100000">
                  <a:srgbClr val="006666"/>
                </a:gs>
              </a:gsLst>
              <a:lin ang="108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ffffcc"/>
                </a:solidFill>
                <a:latin typeface="Times New Roman"/>
              </a:endParaRPr>
            </a:p>
          </p:txBody>
        </p:sp>
      </p:grpSp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123840" y="426600"/>
            <a:ext cx="8920080" cy="98100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ccecff"/>
                </a:solidFill>
                <a:latin typeface="LongIsland"/>
              </a:rPr>
              <a:t>Click to edit the title text format</a:t>
            </a:r>
            <a:endParaRPr b="0" lang="en-US" sz="4400" spc="-1" strike="noStrike">
              <a:solidFill>
                <a:srgbClr val="ccecff"/>
              </a:solidFill>
              <a:latin typeface="LongIsland"/>
            </a:endParaRPr>
          </a:p>
        </p:txBody>
      </p:sp>
      <p:sp>
        <p:nvSpPr>
          <p:cNvPr id="54" name="PlaceHolder 2"/>
          <p:cNvSpPr>
            <a:spLocks noGrp="1"/>
          </p:cNvSpPr>
          <p:nvPr>
            <p:ph type="dt" idx="4"/>
          </p:nvPr>
        </p:nvSpPr>
        <p:spPr>
          <a:xfrm>
            <a:off x="112680" y="6351480"/>
            <a:ext cx="2648160" cy="45720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cc"/>
              </a:solidFill>
              <a:latin typeface="Times New Roman"/>
            </a:endParaRPr>
          </a:p>
        </p:txBody>
      </p:sp>
      <p:sp>
        <p:nvSpPr>
          <p:cNvPr id="55" name="PlaceHolder 3"/>
          <p:cNvSpPr>
            <a:spLocks noGrp="1"/>
          </p:cNvSpPr>
          <p:nvPr>
            <p:ph type="ftr" idx="5"/>
          </p:nvPr>
        </p:nvSpPr>
        <p:spPr>
          <a:xfrm>
            <a:off x="2900520" y="6351480"/>
            <a:ext cx="3402000" cy="45720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cc"/>
              </a:solidFill>
              <a:latin typeface="Times New Roman"/>
            </a:endParaRPr>
          </a:p>
        </p:txBody>
      </p:sp>
      <p:sp>
        <p:nvSpPr>
          <p:cNvPr id="56" name="PlaceHolder 4"/>
          <p:cNvSpPr>
            <a:spLocks noGrp="1"/>
          </p:cNvSpPr>
          <p:nvPr>
            <p:ph type="sldNum" idx="6"/>
          </p:nvPr>
        </p:nvSpPr>
        <p:spPr>
          <a:xfrm>
            <a:off x="6441840" y="6351480"/>
            <a:ext cx="2601720" cy="45720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cc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5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hyperlink" Target="http://www.jmir.org/2006" TargetMode="External"/><Relationship Id="rId2" Type="http://schemas.openxmlformats.org/officeDocument/2006/relationships/slideLayout" Target="../slideLayouts/slideLayout3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8080"/>
            </a:gs>
            <a:gs pos="100000">
              <a:srgbClr val="003b3b"/>
            </a:gs>
          </a:gsLst>
          <a:lin ang="135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PlaceHolder 1"/>
          <p:cNvSpPr>
            <a:spLocks noGrp="1"/>
          </p:cNvSpPr>
          <p:nvPr>
            <p:ph type="title"/>
          </p:nvPr>
        </p:nvSpPr>
        <p:spPr>
          <a:xfrm>
            <a:off x="169920" y="215640"/>
            <a:ext cx="8874000" cy="123804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br>
              <a:rPr sz="5400"/>
            </a:br>
            <a:r>
              <a:rPr b="0" lang="en-US" sz="6000" spc="-1" strike="noStrike">
                <a:solidFill>
                  <a:srgbClr val="ccecff"/>
                </a:solidFill>
                <a:latin typeface="LongIsland"/>
              </a:rPr>
              <a:t>Patient Web Portals:</a:t>
            </a:r>
            <a:br>
              <a:rPr sz="6000"/>
            </a:br>
            <a:endParaRPr b="0" lang="en-US" sz="6000" spc="-1" strike="noStrike">
              <a:solidFill>
                <a:srgbClr val="ccecff"/>
              </a:solidFill>
              <a:latin typeface="LongIsland"/>
            </a:endParaRPr>
          </a:p>
        </p:txBody>
      </p:sp>
      <p:sp>
        <p:nvSpPr>
          <p:cNvPr id="94" name="PlaceHolder 2"/>
          <p:cNvSpPr>
            <a:spLocks noGrp="1"/>
          </p:cNvSpPr>
          <p:nvPr>
            <p:ph type="subTitle"/>
          </p:nvPr>
        </p:nvSpPr>
        <p:spPr>
          <a:xfrm>
            <a:off x="0" y="1904760"/>
            <a:ext cx="9144000" cy="106668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cc"/>
                </a:solidFill>
                <a:latin typeface="LongIsland"/>
              </a:rPr>
              <a:t>What’s the Convenience Worth to Patients?</a:t>
            </a: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  <p:sp>
        <p:nvSpPr>
          <p:cNvPr id="95" name=""/>
          <p:cNvSpPr/>
          <p:nvPr/>
        </p:nvSpPr>
        <p:spPr>
          <a:xfrm>
            <a:off x="1066680" y="4419720"/>
            <a:ext cx="6921720" cy="1801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cc"/>
                </a:solidFill>
                <a:latin typeface="LongIsland"/>
              </a:rPr>
              <a:t>Kenneth Adler, MD, MMM</a:t>
            </a:r>
            <a:endParaRPr b="0" lang="en-US" sz="3200" spc="-1" strike="noStrike">
              <a:solidFill>
                <a:srgbClr val="ffffcc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cc"/>
                </a:solidFill>
                <a:latin typeface="LongIsland"/>
              </a:rPr>
              <a:t>Medical Director of Information Technology</a:t>
            </a:r>
            <a:endParaRPr b="0" lang="en-US" sz="2000" spc="-1" strike="noStrike">
              <a:solidFill>
                <a:srgbClr val="ffffcc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cc"/>
                </a:solidFill>
                <a:latin typeface="LongIsland"/>
              </a:rPr>
              <a:t>Arizona Community Physicians</a:t>
            </a:r>
            <a:endParaRPr b="0" lang="en-US" sz="2000" spc="-1" strike="noStrike">
              <a:solidFill>
                <a:srgbClr val="ffffcc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cc"/>
                </a:solidFill>
                <a:latin typeface="LongIsland"/>
              </a:rPr>
              <a:t>Tucson, Arizona</a:t>
            </a:r>
            <a:endParaRPr b="0" lang="en-US" sz="2000" spc="-1" strike="noStrike">
              <a:solidFill>
                <a:srgbClr val="ffffcc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ffffcc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8080"/>
            </a:gs>
            <a:gs pos="100000">
              <a:srgbClr val="003b3b"/>
            </a:gs>
          </a:gsLst>
          <a:lin ang="135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PlaceHolder 1"/>
          <p:cNvSpPr>
            <a:spLocks noGrp="1"/>
          </p:cNvSpPr>
          <p:nvPr>
            <p:ph type="title"/>
          </p:nvPr>
        </p:nvSpPr>
        <p:spPr>
          <a:xfrm>
            <a:off x="169920" y="215640"/>
            <a:ext cx="8874000" cy="123804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ccecff"/>
                </a:solidFill>
                <a:latin typeface="LongIsland"/>
              </a:rPr>
              <a:t>Study Methods</a:t>
            </a:r>
            <a:endParaRPr b="0" lang="en-US" sz="4400" spc="-1" strike="noStrike">
              <a:solidFill>
                <a:srgbClr val="ccecff"/>
              </a:solidFill>
              <a:latin typeface="LongIsland"/>
            </a:endParaRPr>
          </a:p>
        </p:txBody>
      </p:sp>
      <p:sp>
        <p:nvSpPr>
          <p:cNvPr id="113" name="PlaceHolder 2"/>
          <p:cNvSpPr>
            <a:spLocks noGrp="1"/>
          </p:cNvSpPr>
          <p:nvPr>
            <p:ph/>
          </p:nvPr>
        </p:nvSpPr>
        <p:spPr>
          <a:xfrm>
            <a:off x="182160" y="1828440"/>
            <a:ext cx="8837640" cy="441180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 fontScale="89000"/>
          </a:bodyPr>
          <a:p>
            <a:pPr marL="305280" indent="-305280">
              <a:lnSpc>
                <a:spcPct val="90000"/>
              </a:lnSpc>
              <a:spcBef>
                <a:spcPts val="700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cc"/>
                </a:solidFill>
                <a:latin typeface="LongIsland"/>
              </a:rPr>
              <a:t>Practice site:    </a:t>
            </a:r>
            <a:r>
              <a:rPr b="0" lang="en-US" sz="2800" spc="-1" strike="noStrike">
                <a:solidFill>
                  <a:srgbClr val="ffffcc"/>
                </a:solidFill>
                <a:latin typeface="LongIsland"/>
              </a:rPr>
              <a:t>Author’s family medicine practice in Tucson, Arizona</a:t>
            </a: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  <a:p>
            <a:pPr marL="305280" indent="0">
              <a:lnSpc>
                <a:spcPct val="90000"/>
              </a:lnSpc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  <a:p>
            <a:pPr marL="305280" indent="-305280">
              <a:lnSpc>
                <a:spcPct val="90000"/>
              </a:lnSpc>
              <a:spcBef>
                <a:spcPts val="700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cc"/>
                </a:solidFill>
                <a:latin typeface="LongIsland"/>
              </a:rPr>
              <a:t>Survey:   </a:t>
            </a:r>
            <a:r>
              <a:rPr b="0" lang="en-US" sz="2800" spc="-1" strike="noStrike">
                <a:solidFill>
                  <a:srgbClr val="ffffcc"/>
                </a:solidFill>
                <a:latin typeface="LongIsland"/>
              </a:rPr>
              <a:t>One page </a:t>
            </a:r>
            <a:r>
              <a:rPr b="0" lang="en-US" sz="2800" spc="-1" strike="noStrike" u="sng">
                <a:solidFill>
                  <a:srgbClr val="ffffcc"/>
                </a:solidFill>
                <a:uFillTx/>
                <a:latin typeface="LongIsland"/>
              </a:rPr>
              <a:t>anonymous</a:t>
            </a:r>
            <a:r>
              <a:rPr b="0" lang="en-US" sz="2800" spc="-1" strike="noStrike">
                <a:solidFill>
                  <a:srgbClr val="ffffcc"/>
                </a:solidFill>
                <a:latin typeface="LongIsland"/>
              </a:rPr>
              <a:t> survey given to all patients seen for a one month period in the spring of 2006</a:t>
            </a: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  <a:p>
            <a:pPr marL="305280" indent="0">
              <a:lnSpc>
                <a:spcPct val="90000"/>
              </a:lnSpc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  <a:p>
            <a:pPr marL="305280" indent="-305280">
              <a:lnSpc>
                <a:spcPct val="90000"/>
              </a:lnSpc>
              <a:spcBef>
                <a:spcPts val="700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cc"/>
                </a:solidFill>
                <a:latin typeface="LongIsland"/>
              </a:rPr>
              <a:t>Analysis</a:t>
            </a:r>
            <a:r>
              <a:rPr b="0" lang="en-US" sz="2800" spc="-1" strike="noStrike">
                <a:solidFill>
                  <a:srgbClr val="ffffcc"/>
                </a:solidFill>
                <a:latin typeface="LongIsland"/>
              </a:rPr>
              <a:t>:  </a:t>
            </a: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  <a:p>
            <a:pPr lvl="1" marL="660960" indent="-254160">
              <a:lnSpc>
                <a:spcPct val="90000"/>
              </a:lnSpc>
              <a:spcBef>
                <a:spcPts val="601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cc"/>
                </a:solidFill>
                <a:latin typeface="LongIsland"/>
              </a:rPr>
              <a:t>Access database</a:t>
            </a:r>
            <a:endParaRPr b="0" lang="en-US" sz="2400" spc="-1" strike="noStrike">
              <a:solidFill>
                <a:srgbClr val="ffffcc"/>
              </a:solidFill>
              <a:latin typeface="LongIsland"/>
            </a:endParaRPr>
          </a:p>
          <a:p>
            <a:pPr lvl="1" marL="660960" indent="-254160">
              <a:lnSpc>
                <a:spcPct val="90000"/>
              </a:lnSpc>
              <a:spcBef>
                <a:spcPts val="601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cc"/>
                </a:solidFill>
                <a:latin typeface="LongIsland"/>
              </a:rPr>
              <a:t>StatsDirect statistical software</a:t>
            </a:r>
            <a:endParaRPr b="0" lang="en-US" sz="2400" spc="-1" strike="noStrike">
              <a:solidFill>
                <a:srgbClr val="ffffcc"/>
              </a:solidFill>
              <a:latin typeface="LongIsland"/>
            </a:endParaRPr>
          </a:p>
          <a:p>
            <a:pPr lvl="1" marL="660960" indent="-254160">
              <a:lnSpc>
                <a:spcPct val="90000"/>
              </a:lnSpc>
              <a:spcBef>
                <a:spcPts val="601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cc"/>
                </a:solidFill>
                <a:latin typeface="LongIsland"/>
              </a:rPr>
              <a:t>Test of significance – Fisher exact test</a:t>
            </a:r>
            <a:endParaRPr b="0" lang="en-US" sz="2400" spc="-1" strike="noStrike">
              <a:solidFill>
                <a:srgbClr val="ffffcc"/>
              </a:solidFill>
              <a:latin typeface="LongIsland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8080"/>
            </a:gs>
            <a:gs pos="100000">
              <a:srgbClr val="003b3b"/>
            </a:gs>
          </a:gsLst>
          <a:lin ang="135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PlaceHolder 1"/>
          <p:cNvSpPr>
            <a:spLocks noGrp="1"/>
          </p:cNvSpPr>
          <p:nvPr>
            <p:ph type="title"/>
          </p:nvPr>
        </p:nvSpPr>
        <p:spPr>
          <a:xfrm>
            <a:off x="169920" y="215640"/>
            <a:ext cx="8874000" cy="123804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ccecff"/>
                </a:solidFill>
                <a:latin typeface="LongIsland"/>
              </a:rPr>
              <a:t>Study Findings – </a:t>
            </a:r>
            <a:br>
              <a:rPr sz="4400"/>
            </a:br>
            <a:r>
              <a:rPr b="0" lang="en-US" sz="4000" spc="-1" strike="noStrike">
                <a:solidFill>
                  <a:srgbClr val="ccecff"/>
                </a:solidFill>
                <a:latin typeface="LongIsland"/>
              </a:rPr>
              <a:t>Return rate and</a:t>
            </a:r>
            <a:r>
              <a:rPr b="0" lang="en-US" sz="4400" spc="-1" strike="noStrike">
                <a:solidFill>
                  <a:srgbClr val="ccecff"/>
                </a:solidFill>
                <a:latin typeface="LongIsland"/>
              </a:rPr>
              <a:t> </a:t>
            </a:r>
            <a:r>
              <a:rPr b="0" lang="en-US" sz="4000" spc="-1" strike="noStrike">
                <a:solidFill>
                  <a:srgbClr val="ccecff"/>
                </a:solidFill>
                <a:latin typeface="LongIsland"/>
              </a:rPr>
              <a:t>Internet access</a:t>
            </a:r>
            <a:endParaRPr b="0" lang="en-US" sz="4000" spc="-1" strike="noStrike">
              <a:solidFill>
                <a:srgbClr val="ccecff"/>
              </a:solidFill>
              <a:latin typeface="LongIsland"/>
            </a:endParaRPr>
          </a:p>
        </p:txBody>
      </p:sp>
      <p:sp>
        <p:nvSpPr>
          <p:cNvPr id="115" name="PlaceHolder 2"/>
          <p:cNvSpPr>
            <a:spLocks noGrp="1"/>
          </p:cNvSpPr>
          <p:nvPr>
            <p:ph/>
          </p:nvPr>
        </p:nvSpPr>
        <p:spPr>
          <a:xfrm>
            <a:off x="182160" y="1801440"/>
            <a:ext cx="8837640" cy="505620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marL="343080" indent="-343080">
              <a:spcBef>
                <a:spcPts val="901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ffffcc"/>
                </a:solidFill>
                <a:latin typeface="LongIsland"/>
              </a:rPr>
              <a:t>Return rate</a:t>
            </a:r>
            <a:r>
              <a:rPr b="0" lang="en-US" sz="3600" spc="-1" strike="noStrike">
                <a:solidFill>
                  <a:srgbClr val="ffffcc"/>
                </a:solidFill>
                <a:latin typeface="LongIsland"/>
              </a:rPr>
              <a:t>	</a:t>
            </a:r>
            <a:endParaRPr b="0" lang="en-US" sz="3600" spc="-1" strike="noStrike">
              <a:solidFill>
                <a:srgbClr val="ffffcc"/>
              </a:solidFill>
              <a:latin typeface="LongIsland"/>
            </a:endParaRPr>
          </a:p>
          <a:p>
            <a:pPr lvl="1" marL="743040" indent="-285840">
              <a:spcBef>
                <a:spcPts val="700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cc"/>
                </a:solidFill>
                <a:latin typeface="LongIsland"/>
              </a:rPr>
              <a:t>346 unique patients seen</a:t>
            </a: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  <a:p>
            <a:pPr lvl="1" marL="743040" indent="-285840">
              <a:spcBef>
                <a:spcPts val="700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cc"/>
                </a:solidFill>
                <a:latin typeface="LongIsland"/>
              </a:rPr>
              <a:t>97.4% return rate</a:t>
            </a: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  <a:p>
            <a:pPr lvl="1" marL="743040" indent="-285840">
              <a:spcBef>
                <a:spcPts val="700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cc"/>
                </a:solidFill>
                <a:latin typeface="LongIsland"/>
              </a:rPr>
              <a:t>95.1% valid survey return rate</a:t>
            </a: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  <a:p>
            <a:pPr marL="343080" indent="-343080">
              <a:spcBef>
                <a:spcPts val="901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ffffcc"/>
                </a:solidFill>
                <a:latin typeface="LongIsland"/>
              </a:rPr>
              <a:t>Internet access</a:t>
            </a:r>
            <a:endParaRPr b="0" lang="en-US" sz="3600" spc="-1" strike="noStrike">
              <a:solidFill>
                <a:srgbClr val="ffffcc"/>
              </a:solidFill>
              <a:latin typeface="LongIsland"/>
            </a:endParaRPr>
          </a:p>
          <a:p>
            <a:pPr lvl="1" marL="743040" indent="-285840">
              <a:spcBef>
                <a:spcPts val="700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cc"/>
                </a:solidFill>
                <a:latin typeface="LongIsland"/>
              </a:rPr>
              <a:t>75.4% overall had Internet access</a:t>
            </a: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  <a:p>
            <a:pPr lvl="1" marL="743040" indent="-285840">
              <a:spcBef>
                <a:spcPts val="700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cc"/>
                </a:solidFill>
                <a:latin typeface="LongIsland"/>
              </a:rPr>
              <a:t>Students and employed had best access</a:t>
            </a: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  <a:p>
            <a:pPr lvl="1" marL="743040" indent="-285840">
              <a:spcBef>
                <a:spcPts val="700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cc"/>
                </a:solidFill>
                <a:latin typeface="LongIsland"/>
              </a:rPr>
              <a:t>41% of respondents were 60 and older</a:t>
            </a: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  <a:p>
            <a:pPr lvl="1" marL="743040" indent="-285840">
              <a:spcBef>
                <a:spcPts val="700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cc"/>
                </a:solidFill>
                <a:latin typeface="LongIsland"/>
              </a:rPr>
              <a:t>66% of retirees had Internet access</a:t>
            </a: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  <a:p>
            <a:pPr lvl="1" marL="743040"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  <a:p>
            <a:pPr lvl="1" marL="743040"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8080"/>
            </a:gs>
            <a:gs pos="100000">
              <a:srgbClr val="003b3b"/>
            </a:gs>
          </a:gsLst>
          <a:lin ang="135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169920" y="215640"/>
            <a:ext cx="8874000" cy="123804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ccecff"/>
                </a:solidFill>
                <a:latin typeface="LongIsland"/>
              </a:rPr>
              <a:t>Study Findings – </a:t>
            </a:r>
            <a:br>
              <a:rPr sz="4400"/>
            </a:br>
            <a:r>
              <a:rPr b="0" lang="en-US" sz="4000" spc="-1" strike="noStrike">
                <a:solidFill>
                  <a:srgbClr val="ccecff"/>
                </a:solidFill>
                <a:latin typeface="LongIsland"/>
              </a:rPr>
              <a:t>Willingness to pay a small annual fee</a:t>
            </a:r>
            <a:endParaRPr b="0" lang="en-US" sz="4000" spc="-1" strike="noStrike">
              <a:solidFill>
                <a:srgbClr val="ccecff"/>
              </a:solidFill>
              <a:latin typeface="LongIsland"/>
            </a:endParaRPr>
          </a:p>
        </p:txBody>
      </p:sp>
      <p:sp>
        <p:nvSpPr>
          <p:cNvPr id="117" name="PlaceHolder 2"/>
          <p:cNvSpPr>
            <a:spLocks noGrp="1"/>
          </p:cNvSpPr>
          <p:nvPr>
            <p:ph/>
          </p:nvPr>
        </p:nvSpPr>
        <p:spPr>
          <a:xfrm>
            <a:off x="182160" y="1801440"/>
            <a:ext cx="8837640" cy="505620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 fontScale="94000"/>
          </a:bodyPr>
          <a:p>
            <a:pPr marL="322200" indent="-322200">
              <a:lnSpc>
                <a:spcPct val="90000"/>
              </a:lnSpc>
              <a:spcBef>
                <a:spcPts val="700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 u="sng">
                <a:solidFill>
                  <a:srgbClr val="ffffcc"/>
                </a:solidFill>
                <a:uFillTx/>
                <a:latin typeface="LongIsland"/>
              </a:rPr>
              <a:t>Three-quarters</a:t>
            </a:r>
            <a:r>
              <a:rPr b="0" lang="en-US" sz="2800" spc="-1" strike="noStrike">
                <a:solidFill>
                  <a:srgbClr val="ffffcc"/>
                </a:solidFill>
                <a:latin typeface="LongIsland"/>
              </a:rPr>
              <a:t> (74.6%) of all online patients were willing to pay a small </a:t>
            </a:r>
            <a:r>
              <a:rPr b="0" lang="en-US" sz="2800" spc="-1" strike="noStrike" u="sng">
                <a:solidFill>
                  <a:srgbClr val="ffffcc"/>
                </a:solidFill>
                <a:uFillTx/>
                <a:latin typeface="LongIsland"/>
              </a:rPr>
              <a:t>annual fee</a:t>
            </a:r>
            <a:r>
              <a:rPr b="0" lang="en-US" sz="2800" spc="-1" strike="noStrike">
                <a:solidFill>
                  <a:srgbClr val="ffffcc"/>
                </a:solidFill>
                <a:latin typeface="LongIsland"/>
              </a:rPr>
              <a:t> for online services</a:t>
            </a: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  <a:p>
            <a:pPr marL="322200" indent="0">
              <a:lnSpc>
                <a:spcPct val="90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  <a:p>
            <a:pPr marL="322200" indent="-322200">
              <a:lnSpc>
                <a:spcPct val="90000"/>
              </a:lnSpc>
              <a:spcBef>
                <a:spcPts val="700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cc"/>
                </a:solidFill>
                <a:latin typeface="LongIsland"/>
              </a:rPr>
              <a:t>Even 12% of patients without their own Internet access were willing to pay a fee</a:t>
            </a: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  <a:p>
            <a:pPr marL="322200" indent="0">
              <a:lnSpc>
                <a:spcPct val="90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  <a:p>
            <a:pPr marL="322200" indent="-322200">
              <a:lnSpc>
                <a:spcPct val="90000"/>
              </a:lnSpc>
              <a:spcBef>
                <a:spcPts val="700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cc"/>
                </a:solidFill>
                <a:latin typeface="LongIsland"/>
              </a:rPr>
              <a:t>60% of those with Internet access were willing to pay US $10 or more per year and over 30% were willing to pay US $50 or more per year</a:t>
            </a: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  <a:p>
            <a:pPr marL="322200" indent="0">
              <a:lnSpc>
                <a:spcPct val="90000"/>
              </a:lnSpc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  <a:p>
            <a:pPr marL="322200" indent="-322200">
              <a:lnSpc>
                <a:spcPct val="90000"/>
              </a:lnSpc>
              <a:spcBef>
                <a:spcPts val="700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cc"/>
                </a:solidFill>
                <a:latin typeface="LongIsland"/>
              </a:rPr>
              <a:t>Willingness to pay did </a:t>
            </a:r>
            <a:r>
              <a:rPr b="0" lang="en-US" sz="2800" spc="-1" strike="noStrike" u="sng">
                <a:solidFill>
                  <a:srgbClr val="ffffcc"/>
                </a:solidFill>
                <a:uFillTx/>
                <a:latin typeface="LongIsland"/>
              </a:rPr>
              <a:t>not</a:t>
            </a:r>
            <a:r>
              <a:rPr b="0" lang="en-US" sz="2800" spc="-1" strike="noStrike">
                <a:solidFill>
                  <a:srgbClr val="ffffcc"/>
                </a:solidFill>
                <a:latin typeface="LongIsland"/>
              </a:rPr>
              <a:t> vary significantly by age</a:t>
            </a: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8080"/>
            </a:gs>
            <a:gs pos="100000">
              <a:srgbClr val="003b3b"/>
            </a:gs>
          </a:gsLst>
          <a:lin ang="135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PlaceHolder 1"/>
          <p:cNvSpPr>
            <a:spLocks noGrp="1"/>
          </p:cNvSpPr>
          <p:nvPr>
            <p:ph type="title"/>
          </p:nvPr>
        </p:nvSpPr>
        <p:spPr>
          <a:xfrm>
            <a:off x="169920" y="215640"/>
            <a:ext cx="8874000" cy="123804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ccecff"/>
                </a:solidFill>
                <a:latin typeface="LongIsland"/>
              </a:rPr>
              <a:t>Study Findings –</a:t>
            </a:r>
            <a:br>
              <a:rPr sz="4400"/>
            </a:br>
            <a:r>
              <a:rPr b="0" lang="en-US" sz="4000" spc="-1" strike="noStrike">
                <a:solidFill>
                  <a:srgbClr val="ccecff"/>
                </a:solidFill>
                <a:latin typeface="LongIsland"/>
              </a:rPr>
              <a:t>Most important online services</a:t>
            </a:r>
            <a:endParaRPr b="0" lang="en-US" sz="4000" spc="-1" strike="noStrike">
              <a:solidFill>
                <a:srgbClr val="ccecff"/>
              </a:solidFill>
              <a:latin typeface="LongIsland"/>
            </a:endParaRPr>
          </a:p>
        </p:txBody>
      </p:sp>
      <p:sp>
        <p:nvSpPr>
          <p:cNvPr id="119" name="PlaceHolder 2"/>
          <p:cNvSpPr>
            <a:spLocks noGrp="1"/>
          </p:cNvSpPr>
          <p:nvPr>
            <p:ph/>
          </p:nvPr>
        </p:nvSpPr>
        <p:spPr>
          <a:xfrm>
            <a:off x="0" y="1752120"/>
            <a:ext cx="9020160" cy="495324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 fontScale="97000"/>
          </a:bodyPr>
          <a:p>
            <a:pPr marL="332640" indent="-332640">
              <a:lnSpc>
                <a:spcPct val="90000"/>
              </a:lnSpc>
              <a:spcBef>
                <a:spcPts val="700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cc"/>
                </a:solidFill>
                <a:latin typeface="LongIsland"/>
              </a:rPr>
              <a:t>When asked to rank the </a:t>
            </a:r>
            <a:r>
              <a:rPr b="0" lang="en-US" sz="2800" spc="-1" strike="noStrike" u="sng">
                <a:solidFill>
                  <a:srgbClr val="ffffcc"/>
                </a:solidFill>
                <a:uFillTx/>
                <a:latin typeface="LongIsland"/>
              </a:rPr>
              <a:t>one</a:t>
            </a:r>
            <a:r>
              <a:rPr b="0" lang="en-US" sz="2800" spc="-1" strike="noStrike">
                <a:solidFill>
                  <a:srgbClr val="ffffcc"/>
                </a:solidFill>
                <a:latin typeface="LongIsland"/>
              </a:rPr>
              <a:t> most important online service with their physician (choice of 5), no single service was selected by  a majority </a:t>
            </a: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  <a:p>
            <a:pPr marL="332640" indent="0">
              <a:lnSpc>
                <a:spcPct val="90000"/>
              </a:lnSpc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  <a:p>
            <a:pPr marL="332640" indent="-332640">
              <a:lnSpc>
                <a:spcPct val="90000"/>
              </a:lnSpc>
              <a:spcBef>
                <a:spcPts val="799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cc"/>
                </a:solidFill>
                <a:latin typeface="LongIsland"/>
              </a:rPr>
              <a:t>The </a:t>
            </a:r>
            <a:r>
              <a:rPr b="0" lang="en-US" sz="3200" spc="-1" strike="noStrike" u="sng">
                <a:solidFill>
                  <a:srgbClr val="ffffcc"/>
                </a:solidFill>
                <a:uFillTx/>
                <a:latin typeface="LongIsland"/>
              </a:rPr>
              <a:t>most important</a:t>
            </a:r>
            <a:r>
              <a:rPr b="0" lang="en-US" sz="3200" spc="-1" strike="noStrike">
                <a:solidFill>
                  <a:srgbClr val="ffffcc"/>
                </a:solidFill>
                <a:latin typeface="LongIsland"/>
              </a:rPr>
              <a:t> online service (in order)</a:t>
            </a: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  <a:p>
            <a:pPr lvl="1" marL="720720" indent="-277200">
              <a:lnSpc>
                <a:spcPct val="90000"/>
              </a:lnSpc>
              <a:spcBef>
                <a:spcPts val="601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cc"/>
                </a:solidFill>
                <a:latin typeface="LongIsland"/>
              </a:rPr>
              <a:t>Email communication with physician (34%)</a:t>
            </a:r>
            <a:endParaRPr b="0" lang="en-US" sz="2400" spc="-1" strike="noStrike">
              <a:solidFill>
                <a:srgbClr val="ffffcc"/>
              </a:solidFill>
              <a:latin typeface="LongIsland"/>
            </a:endParaRPr>
          </a:p>
          <a:p>
            <a:pPr lvl="1" marL="720720" indent="-277200">
              <a:lnSpc>
                <a:spcPct val="90000"/>
              </a:lnSpc>
              <a:spcBef>
                <a:spcPts val="601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cc"/>
                </a:solidFill>
                <a:latin typeface="LongIsland"/>
              </a:rPr>
              <a:t>Viewing own records online (22%)</a:t>
            </a:r>
            <a:endParaRPr b="0" lang="en-US" sz="2400" spc="-1" strike="noStrike">
              <a:solidFill>
                <a:srgbClr val="ffffcc"/>
              </a:solidFill>
              <a:latin typeface="LongIsland"/>
            </a:endParaRPr>
          </a:p>
          <a:p>
            <a:pPr lvl="1" marL="720720" indent="-277200">
              <a:lnSpc>
                <a:spcPct val="90000"/>
              </a:lnSpc>
              <a:spcBef>
                <a:spcPts val="601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cc"/>
                </a:solidFill>
                <a:latin typeface="LongIsland"/>
              </a:rPr>
              <a:t>Medication refilling (11%)</a:t>
            </a:r>
            <a:endParaRPr b="0" lang="en-US" sz="2400" spc="-1" strike="noStrike">
              <a:solidFill>
                <a:srgbClr val="ffffcc"/>
              </a:solidFill>
              <a:latin typeface="LongIsland"/>
            </a:endParaRPr>
          </a:p>
          <a:p>
            <a:pPr lvl="1" marL="720720" indent="-277200">
              <a:lnSpc>
                <a:spcPct val="90000"/>
              </a:lnSpc>
              <a:spcBef>
                <a:spcPts val="601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cc"/>
                </a:solidFill>
                <a:latin typeface="LongIsland"/>
              </a:rPr>
              <a:t>Multiple choices (7%)</a:t>
            </a:r>
            <a:endParaRPr b="0" lang="en-US" sz="2400" spc="-1" strike="noStrike">
              <a:solidFill>
                <a:srgbClr val="ffffcc"/>
              </a:solidFill>
              <a:latin typeface="LongIsland"/>
            </a:endParaRPr>
          </a:p>
          <a:p>
            <a:pPr lvl="1" marL="720720" indent="-277200">
              <a:lnSpc>
                <a:spcPct val="90000"/>
              </a:lnSpc>
              <a:spcBef>
                <a:spcPts val="601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cc"/>
                </a:solidFill>
                <a:latin typeface="LongIsland"/>
              </a:rPr>
              <a:t>Appointment requesting (6%)</a:t>
            </a:r>
            <a:endParaRPr b="0" lang="en-US" sz="2400" spc="-1" strike="noStrike">
              <a:solidFill>
                <a:srgbClr val="ffffcc"/>
              </a:solidFill>
              <a:latin typeface="LongIsland"/>
            </a:endParaRPr>
          </a:p>
          <a:p>
            <a:pPr lvl="1" marL="720720" indent="-277200">
              <a:lnSpc>
                <a:spcPct val="90000"/>
              </a:lnSpc>
              <a:spcBef>
                <a:spcPts val="601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cc"/>
                </a:solidFill>
                <a:latin typeface="LongIsland"/>
              </a:rPr>
              <a:t>Billing inquires (0%)</a:t>
            </a:r>
            <a:endParaRPr b="0" lang="en-US" sz="2400" spc="-1" strike="noStrike">
              <a:solidFill>
                <a:srgbClr val="ffffcc"/>
              </a:solidFill>
              <a:latin typeface="LongIsland"/>
            </a:endParaRPr>
          </a:p>
          <a:p>
            <a:pPr lvl="1" marL="720720" indent="-277200">
              <a:lnSpc>
                <a:spcPct val="90000"/>
              </a:lnSpc>
              <a:spcBef>
                <a:spcPts val="601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cc"/>
                </a:solidFill>
                <a:latin typeface="LongIsland"/>
              </a:rPr>
              <a:t>No response (19%)</a:t>
            </a:r>
            <a:endParaRPr b="0" lang="en-US" sz="2400" spc="-1" strike="noStrike">
              <a:solidFill>
                <a:srgbClr val="ffffcc"/>
              </a:solidFill>
              <a:latin typeface="LongIsland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8080"/>
            </a:gs>
            <a:gs pos="100000">
              <a:srgbClr val="003b3b"/>
            </a:gs>
          </a:gsLst>
          <a:lin ang="135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PlaceHolder 1"/>
          <p:cNvSpPr>
            <a:spLocks noGrp="1"/>
          </p:cNvSpPr>
          <p:nvPr>
            <p:ph type="title"/>
          </p:nvPr>
        </p:nvSpPr>
        <p:spPr>
          <a:xfrm>
            <a:off x="169920" y="215640"/>
            <a:ext cx="8874000" cy="123804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ccecff"/>
                </a:solidFill>
                <a:latin typeface="LongIsland"/>
              </a:rPr>
              <a:t>Potential Study Limitations</a:t>
            </a:r>
            <a:endParaRPr b="0" lang="en-US" sz="4400" spc="-1" strike="noStrike">
              <a:solidFill>
                <a:srgbClr val="ccecff"/>
              </a:solidFill>
              <a:latin typeface="LongIsland"/>
            </a:endParaRPr>
          </a:p>
        </p:txBody>
      </p:sp>
      <p:sp>
        <p:nvSpPr>
          <p:cNvPr id="121" name="PlaceHolder 2"/>
          <p:cNvSpPr>
            <a:spLocks noGrp="1"/>
          </p:cNvSpPr>
          <p:nvPr>
            <p:ph/>
          </p:nvPr>
        </p:nvSpPr>
        <p:spPr>
          <a:xfrm>
            <a:off x="182160" y="1801800"/>
            <a:ext cx="8837640" cy="443880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marL="343080" indent="-343080">
              <a:lnSpc>
                <a:spcPct val="90000"/>
              </a:lnSpc>
              <a:spcBef>
                <a:spcPts val="799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cc"/>
                </a:solidFill>
                <a:latin typeface="LongIsland"/>
              </a:rPr>
              <a:t>Can the results be generalized ?</a:t>
            </a:r>
            <a:r>
              <a:rPr b="0" lang="en-US" sz="3200" spc="-1" strike="noStrike">
                <a:solidFill>
                  <a:srgbClr val="ffffcc"/>
                </a:solidFill>
                <a:latin typeface="LongIsland"/>
              </a:rPr>
              <a:t>	</a:t>
            </a: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  <a:p>
            <a:pPr lvl="1" marL="743040" indent="-285840">
              <a:lnSpc>
                <a:spcPct val="90000"/>
              </a:lnSpc>
              <a:spcBef>
                <a:spcPts val="700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cc"/>
                </a:solidFill>
                <a:latin typeface="LongIsland"/>
              </a:rPr>
              <a:t>To other practices?</a:t>
            </a: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  <a:p>
            <a:pPr lvl="1" marL="743040" indent="-285840">
              <a:lnSpc>
                <a:spcPct val="90000"/>
              </a:lnSpc>
              <a:spcBef>
                <a:spcPts val="700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cc"/>
                </a:solidFill>
                <a:latin typeface="LongIsland"/>
              </a:rPr>
              <a:t>To other cities?</a:t>
            </a: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  <a:p>
            <a:pPr lvl="1" marL="743040" indent="-285840">
              <a:lnSpc>
                <a:spcPct val="90000"/>
              </a:lnSpc>
              <a:spcBef>
                <a:spcPts val="700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cc"/>
                </a:solidFill>
                <a:latin typeface="LongIsland"/>
              </a:rPr>
              <a:t>To other countries?</a:t>
            </a: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  <a:p>
            <a:pPr lvl="1" marL="743040" indent="-285840">
              <a:lnSpc>
                <a:spcPct val="90000"/>
              </a:lnSpc>
              <a:spcBef>
                <a:spcPts val="700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cc"/>
                </a:solidFill>
                <a:latin typeface="LongIsland"/>
              </a:rPr>
              <a:t>To other types of medical practices?</a:t>
            </a: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  <a:p>
            <a:pPr lvl="1" marL="743040" indent="0">
              <a:lnSpc>
                <a:spcPct val="90000"/>
              </a:lnSpc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  <a:p>
            <a:pPr marL="343080" indent="-343080">
              <a:lnSpc>
                <a:spcPct val="90000"/>
              </a:lnSpc>
              <a:spcBef>
                <a:spcPts val="799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cc"/>
                </a:solidFill>
                <a:latin typeface="LongIsland"/>
              </a:rPr>
              <a:t>Would patients pay an annual access fee </a:t>
            </a:r>
            <a:r>
              <a:rPr b="0" lang="en-US" sz="3200" spc="-1" strike="noStrike" u="sng">
                <a:solidFill>
                  <a:srgbClr val="ffffcc"/>
                </a:solidFill>
                <a:uFillTx/>
                <a:latin typeface="LongIsland"/>
              </a:rPr>
              <a:t>and </a:t>
            </a:r>
            <a:r>
              <a:rPr b="0" lang="en-US" sz="3200" spc="-1" strike="noStrike">
                <a:solidFill>
                  <a:srgbClr val="ffffcc"/>
                </a:solidFill>
                <a:latin typeface="LongIsland"/>
              </a:rPr>
              <a:t>a per transaction fee for e-consults? This wasn’t studied.</a:t>
            </a: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  <a:p>
            <a:pPr lvl="1" marL="743040" indent="0">
              <a:lnSpc>
                <a:spcPct val="90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  <a:p>
            <a:pPr marL="343080" indent="0">
              <a:lnSpc>
                <a:spcPct val="90000"/>
              </a:lnSpc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8080"/>
            </a:gs>
            <a:gs pos="100000">
              <a:srgbClr val="003b3b"/>
            </a:gs>
          </a:gsLst>
          <a:lin ang="135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PlaceHolder 1"/>
          <p:cNvSpPr>
            <a:spLocks noGrp="1"/>
          </p:cNvSpPr>
          <p:nvPr>
            <p:ph type="title"/>
          </p:nvPr>
        </p:nvSpPr>
        <p:spPr>
          <a:xfrm>
            <a:off x="169920" y="215640"/>
            <a:ext cx="8874000" cy="123804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ccecff"/>
                </a:solidFill>
                <a:latin typeface="LongIsland"/>
              </a:rPr>
              <a:t>Suggestions for future research</a:t>
            </a:r>
            <a:endParaRPr b="0" lang="en-US" sz="4400" spc="-1" strike="noStrike">
              <a:solidFill>
                <a:srgbClr val="ccecff"/>
              </a:solidFill>
              <a:latin typeface="LongIsland"/>
            </a:endParaRPr>
          </a:p>
        </p:txBody>
      </p:sp>
      <p:sp>
        <p:nvSpPr>
          <p:cNvPr id="123" name="PlaceHolder 2"/>
          <p:cNvSpPr>
            <a:spLocks noGrp="1"/>
          </p:cNvSpPr>
          <p:nvPr>
            <p:ph/>
          </p:nvPr>
        </p:nvSpPr>
        <p:spPr>
          <a:xfrm>
            <a:off x="151920" y="2209680"/>
            <a:ext cx="8837640" cy="443880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marL="343080" indent="-343080">
              <a:spcBef>
                <a:spcPts val="799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cc"/>
                </a:solidFill>
                <a:latin typeface="LongIsland"/>
              </a:rPr>
              <a:t>Repeat this study in other settings</a:t>
            </a: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  <a:p>
            <a:pPr marL="343080" indent="-343080">
              <a:spcBef>
                <a:spcPts val="799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cc"/>
                </a:solidFill>
                <a:latin typeface="LongIsland"/>
              </a:rPr>
              <a:t>Implement a patient web portal  with a small annual fee and a typical e-consult fee and determine how many people out of a defined practice actually pay the annual fee and how many utilize e-consults </a:t>
            </a: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8080"/>
            </a:gs>
            <a:gs pos="100000">
              <a:srgbClr val="003b3b"/>
            </a:gs>
          </a:gsLst>
          <a:lin ang="135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PlaceHolder 1"/>
          <p:cNvSpPr>
            <a:spLocks noGrp="1"/>
          </p:cNvSpPr>
          <p:nvPr>
            <p:ph type="title"/>
          </p:nvPr>
        </p:nvSpPr>
        <p:spPr>
          <a:xfrm>
            <a:off x="169920" y="215640"/>
            <a:ext cx="8874000" cy="123804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ccecff"/>
                </a:solidFill>
                <a:latin typeface="LongIsland"/>
              </a:rPr>
              <a:t>Conclusions</a:t>
            </a:r>
            <a:endParaRPr b="0" lang="en-US" sz="4400" spc="-1" strike="noStrike">
              <a:solidFill>
                <a:srgbClr val="ccecff"/>
              </a:solidFill>
              <a:latin typeface="LongIsland"/>
            </a:endParaRPr>
          </a:p>
        </p:txBody>
      </p:sp>
      <p:sp>
        <p:nvSpPr>
          <p:cNvPr id="125" name="PlaceHolder 2"/>
          <p:cNvSpPr>
            <a:spLocks noGrp="1"/>
          </p:cNvSpPr>
          <p:nvPr>
            <p:ph/>
          </p:nvPr>
        </p:nvSpPr>
        <p:spPr>
          <a:xfrm>
            <a:off x="306000" y="1828440"/>
            <a:ext cx="8837640" cy="518148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 fontScale="98000"/>
          </a:bodyPr>
          <a:p>
            <a:pPr marL="335880" indent="-335880">
              <a:lnSpc>
                <a:spcPct val="90000"/>
              </a:lnSpc>
              <a:spcBef>
                <a:spcPts val="799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cc"/>
                </a:solidFill>
                <a:latin typeface="LongIsland"/>
              </a:rPr>
              <a:t>This study suggests that patients are more willing to pay for online services than previously thought</a:t>
            </a: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  <a:p>
            <a:pPr marL="335880" indent="0">
              <a:lnSpc>
                <a:spcPct val="90000"/>
              </a:lnSpc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  <a:p>
            <a:pPr marL="335880" indent="-335880">
              <a:lnSpc>
                <a:spcPct val="90000"/>
              </a:lnSpc>
              <a:spcBef>
                <a:spcPts val="799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cc"/>
                </a:solidFill>
                <a:latin typeface="LongIsland"/>
              </a:rPr>
              <a:t>Although an annual access fee of US $10  sounds small, it could quickly add up.</a:t>
            </a: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  <a:p>
            <a:pPr marL="335880" indent="0">
              <a:lnSpc>
                <a:spcPct val="90000"/>
              </a:lnSpc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  <a:p>
            <a:pPr marL="335880" indent="-335880">
              <a:lnSpc>
                <a:spcPct val="90000"/>
              </a:lnSpc>
              <a:spcBef>
                <a:spcPts val="799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cc"/>
                </a:solidFill>
                <a:latin typeface="LongIsland"/>
              </a:rPr>
              <a:t>If only 50% of a practice of 2500 patients paid US $10 per year, that would amount to US $12,500 per year of additional revenue</a:t>
            </a: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8080"/>
            </a:gs>
            <a:gs pos="100000">
              <a:srgbClr val="003b3b"/>
            </a:gs>
          </a:gsLst>
          <a:lin ang="135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 type="title"/>
          </p:nvPr>
        </p:nvSpPr>
        <p:spPr>
          <a:xfrm>
            <a:off x="169920" y="215640"/>
            <a:ext cx="8874000" cy="123804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ccecff"/>
                </a:solidFill>
                <a:latin typeface="LongIsland"/>
              </a:rPr>
              <a:t>Learning Objectives</a:t>
            </a:r>
            <a:endParaRPr b="0" lang="en-US" sz="4400" spc="-1" strike="noStrike">
              <a:solidFill>
                <a:srgbClr val="ccecff"/>
              </a:solidFill>
              <a:latin typeface="LongIsland"/>
            </a:endParaRPr>
          </a:p>
        </p:txBody>
      </p:sp>
      <p:sp>
        <p:nvSpPr>
          <p:cNvPr id="97" name="PlaceHolder 2"/>
          <p:cNvSpPr>
            <a:spLocks noGrp="1"/>
          </p:cNvSpPr>
          <p:nvPr>
            <p:ph/>
          </p:nvPr>
        </p:nvSpPr>
        <p:spPr>
          <a:xfrm>
            <a:off x="182160" y="1801440"/>
            <a:ext cx="8837640" cy="505620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 fontScale="98000"/>
          </a:bodyPr>
          <a:p>
            <a:pPr marL="335880" indent="-335880">
              <a:spcBef>
                <a:spcPts val="601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 u="sng">
                <a:solidFill>
                  <a:srgbClr val="ffffcc"/>
                </a:solidFill>
                <a:uFillTx/>
                <a:latin typeface="LongIsland"/>
              </a:rPr>
              <a:t>Review</a:t>
            </a:r>
            <a:r>
              <a:rPr b="0" lang="en-US" sz="2400" spc="-1" strike="noStrike">
                <a:solidFill>
                  <a:srgbClr val="ffffcc"/>
                </a:solidFill>
                <a:latin typeface="LongIsland"/>
              </a:rPr>
              <a:t> the benefits of patient web portals (online physician-patient services) for patients and physicians alike</a:t>
            </a:r>
            <a:endParaRPr b="0" lang="en-US" sz="2400" spc="-1" strike="noStrike">
              <a:solidFill>
                <a:srgbClr val="ffffcc"/>
              </a:solidFill>
              <a:latin typeface="LongIsland"/>
            </a:endParaRPr>
          </a:p>
          <a:p>
            <a:pPr marL="335880" indent="-335880">
              <a:spcBef>
                <a:spcPts val="601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 u="sng">
                <a:solidFill>
                  <a:srgbClr val="ffffcc"/>
                </a:solidFill>
                <a:uFillTx/>
                <a:latin typeface="LongIsland"/>
              </a:rPr>
              <a:t>Learn</a:t>
            </a:r>
            <a:r>
              <a:rPr b="0" lang="en-US" sz="2400" spc="-1" strike="noStrike">
                <a:solidFill>
                  <a:srgbClr val="ffffcc"/>
                </a:solidFill>
                <a:latin typeface="LongIsland"/>
              </a:rPr>
              <a:t> about the current barriers to the implementation of patient web portals</a:t>
            </a:r>
            <a:endParaRPr b="0" lang="en-US" sz="2400" spc="-1" strike="noStrike">
              <a:solidFill>
                <a:srgbClr val="ffffcc"/>
              </a:solidFill>
              <a:latin typeface="LongIsland"/>
            </a:endParaRPr>
          </a:p>
          <a:p>
            <a:pPr marL="335880" indent="-335880">
              <a:spcBef>
                <a:spcPts val="601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 u="sng">
                <a:solidFill>
                  <a:srgbClr val="ffffcc"/>
                </a:solidFill>
                <a:uFillTx/>
                <a:latin typeface="LongIsland"/>
              </a:rPr>
              <a:t>State</a:t>
            </a:r>
            <a:r>
              <a:rPr b="0" lang="en-US" sz="2400" spc="-1" strike="noStrike">
                <a:solidFill>
                  <a:srgbClr val="ffffcc"/>
                </a:solidFill>
                <a:latin typeface="LongIsland"/>
              </a:rPr>
              <a:t> what percent of the adult US population has Internet access and what percent desires to have online services with their physician</a:t>
            </a:r>
            <a:endParaRPr b="0" lang="en-US" sz="2400" spc="-1" strike="noStrike">
              <a:solidFill>
                <a:srgbClr val="ffffcc"/>
              </a:solidFill>
              <a:latin typeface="LongIsland"/>
            </a:endParaRPr>
          </a:p>
          <a:p>
            <a:pPr marL="335880" indent="-335880">
              <a:spcBef>
                <a:spcPts val="601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 u="sng">
                <a:solidFill>
                  <a:srgbClr val="ffffcc"/>
                </a:solidFill>
                <a:uFillTx/>
                <a:latin typeface="LongIsland"/>
              </a:rPr>
              <a:t>Discover</a:t>
            </a:r>
            <a:r>
              <a:rPr b="0" lang="en-US" sz="2400" spc="-1" strike="noStrike">
                <a:solidFill>
                  <a:srgbClr val="ffffcc"/>
                </a:solidFill>
                <a:latin typeface="LongIsland"/>
              </a:rPr>
              <a:t> what prior research has said about patient willingness to pay for online services</a:t>
            </a:r>
            <a:endParaRPr b="0" lang="en-US" sz="2400" spc="-1" strike="noStrike">
              <a:solidFill>
                <a:srgbClr val="ffffcc"/>
              </a:solidFill>
              <a:latin typeface="LongIsland"/>
            </a:endParaRPr>
          </a:p>
          <a:p>
            <a:pPr marL="335880" indent="-335880">
              <a:spcBef>
                <a:spcPts val="601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 u="sng">
                <a:solidFill>
                  <a:srgbClr val="ffffcc"/>
                </a:solidFill>
                <a:uFillTx/>
                <a:latin typeface="LongIsland"/>
              </a:rPr>
              <a:t>Examine</a:t>
            </a:r>
            <a:r>
              <a:rPr b="0" lang="en-US" sz="2400" spc="-1" strike="noStrike">
                <a:solidFill>
                  <a:srgbClr val="ffffcc"/>
                </a:solidFill>
                <a:latin typeface="LongIsland"/>
              </a:rPr>
              <a:t> the findings of a study entitled </a:t>
            </a:r>
            <a:r>
              <a:rPr b="0" i="1" lang="en-US" sz="2400" spc="-1" strike="noStrike">
                <a:solidFill>
                  <a:srgbClr val="ffffcc"/>
                </a:solidFill>
                <a:latin typeface="LongIsland"/>
              </a:rPr>
              <a:t>“Web Portals in Primary Care: An evaluation of patient readiness and willingness to pay for online services”</a:t>
            </a:r>
            <a:endParaRPr b="0" lang="en-US" sz="2400" spc="-1" strike="noStrike">
              <a:solidFill>
                <a:srgbClr val="ffffcc"/>
              </a:solidFill>
              <a:latin typeface="LongIsland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8080"/>
            </a:gs>
            <a:gs pos="100000">
              <a:srgbClr val="003b3b"/>
            </a:gs>
          </a:gsLst>
          <a:lin ang="135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PlaceHolder 1"/>
          <p:cNvSpPr>
            <a:spLocks noGrp="1"/>
          </p:cNvSpPr>
          <p:nvPr>
            <p:ph type="title"/>
          </p:nvPr>
        </p:nvSpPr>
        <p:spPr>
          <a:xfrm>
            <a:off x="169920" y="215640"/>
            <a:ext cx="8874000" cy="123804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ccecff"/>
                </a:solidFill>
                <a:latin typeface="LongIsland"/>
              </a:rPr>
              <a:t>What’s a patient web portal ?</a:t>
            </a:r>
            <a:endParaRPr b="0" lang="en-US" sz="4400" spc="-1" strike="noStrike">
              <a:solidFill>
                <a:srgbClr val="ccecff"/>
              </a:solidFill>
              <a:latin typeface="LongIsland"/>
            </a:endParaRPr>
          </a:p>
        </p:txBody>
      </p:sp>
      <p:sp>
        <p:nvSpPr>
          <p:cNvPr id="99" name="PlaceHolder 2"/>
          <p:cNvSpPr>
            <a:spLocks noGrp="1"/>
          </p:cNvSpPr>
          <p:nvPr>
            <p:ph/>
          </p:nvPr>
        </p:nvSpPr>
        <p:spPr>
          <a:xfrm>
            <a:off x="182160" y="1801440"/>
            <a:ext cx="8837640" cy="505620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 fontScale="99000"/>
          </a:bodyPr>
          <a:p>
            <a:pPr marL="339480" indent="-339480">
              <a:lnSpc>
                <a:spcPct val="90000"/>
              </a:lnSpc>
              <a:spcBef>
                <a:spcPts val="700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cc"/>
                </a:solidFill>
                <a:latin typeface="LongIsland"/>
              </a:rPr>
              <a:t>Secure web site – HIPAA compliant</a:t>
            </a: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  <a:p>
            <a:pPr marL="339480" indent="-339480">
              <a:lnSpc>
                <a:spcPct val="90000"/>
              </a:lnSpc>
              <a:spcBef>
                <a:spcPts val="700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cc"/>
                </a:solidFill>
                <a:latin typeface="LongIsland"/>
              </a:rPr>
              <a:t>Asynchronous communication</a:t>
            </a: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  <a:p>
            <a:pPr lvl="1" marL="735480" indent="-282960">
              <a:lnSpc>
                <a:spcPct val="90000"/>
              </a:lnSpc>
              <a:spcBef>
                <a:spcPts val="601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cc"/>
                </a:solidFill>
                <a:latin typeface="LongIsland"/>
              </a:rPr>
              <a:t>can substitute for a phone call, or in some cases, an office visit</a:t>
            </a:r>
            <a:endParaRPr b="0" lang="en-US" sz="2400" spc="-1" strike="noStrike">
              <a:solidFill>
                <a:srgbClr val="ffffcc"/>
              </a:solidFill>
              <a:latin typeface="LongIsland"/>
            </a:endParaRPr>
          </a:p>
          <a:p>
            <a:pPr marL="339480" indent="-339480">
              <a:lnSpc>
                <a:spcPct val="90000"/>
              </a:lnSpc>
              <a:spcBef>
                <a:spcPts val="700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cc"/>
                </a:solidFill>
                <a:latin typeface="LongIsland"/>
              </a:rPr>
              <a:t>Functions</a:t>
            </a: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  <a:p>
            <a:pPr lvl="1" marL="735480" indent="-282960">
              <a:lnSpc>
                <a:spcPct val="90000"/>
              </a:lnSpc>
              <a:spcBef>
                <a:spcPts val="601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cc"/>
                </a:solidFill>
                <a:latin typeface="LongIsland"/>
              </a:rPr>
              <a:t>Appointment requests</a:t>
            </a:r>
            <a:endParaRPr b="0" lang="en-US" sz="2400" spc="-1" strike="noStrike">
              <a:solidFill>
                <a:srgbClr val="ffffcc"/>
              </a:solidFill>
              <a:latin typeface="LongIsland"/>
            </a:endParaRPr>
          </a:p>
          <a:p>
            <a:pPr lvl="1" marL="735480" indent="-282960">
              <a:lnSpc>
                <a:spcPct val="90000"/>
              </a:lnSpc>
              <a:spcBef>
                <a:spcPts val="601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cc"/>
                </a:solidFill>
                <a:latin typeface="LongIsland"/>
              </a:rPr>
              <a:t>Medication refills</a:t>
            </a:r>
            <a:endParaRPr b="0" lang="en-US" sz="2400" spc="-1" strike="noStrike">
              <a:solidFill>
                <a:srgbClr val="ffffcc"/>
              </a:solidFill>
              <a:latin typeface="LongIsland"/>
            </a:endParaRPr>
          </a:p>
          <a:p>
            <a:pPr lvl="1" marL="735480" indent="-282960">
              <a:lnSpc>
                <a:spcPct val="90000"/>
              </a:lnSpc>
              <a:spcBef>
                <a:spcPts val="601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cc"/>
                </a:solidFill>
                <a:latin typeface="LongIsland"/>
              </a:rPr>
              <a:t>Referral requests</a:t>
            </a:r>
            <a:endParaRPr b="0" lang="en-US" sz="2400" spc="-1" strike="noStrike">
              <a:solidFill>
                <a:srgbClr val="ffffcc"/>
              </a:solidFill>
              <a:latin typeface="LongIsland"/>
            </a:endParaRPr>
          </a:p>
          <a:p>
            <a:pPr lvl="1" marL="735480" indent="-282960">
              <a:lnSpc>
                <a:spcPct val="90000"/>
              </a:lnSpc>
              <a:spcBef>
                <a:spcPts val="601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cc"/>
                </a:solidFill>
                <a:latin typeface="LongIsland"/>
              </a:rPr>
              <a:t>E-consults</a:t>
            </a:r>
            <a:endParaRPr b="0" lang="en-US" sz="2400" spc="-1" strike="noStrike">
              <a:solidFill>
                <a:srgbClr val="ffffcc"/>
              </a:solidFill>
              <a:latin typeface="LongIsland"/>
            </a:endParaRPr>
          </a:p>
          <a:p>
            <a:pPr lvl="1" marL="735480" indent="-282960">
              <a:lnSpc>
                <a:spcPct val="90000"/>
              </a:lnSpc>
              <a:spcBef>
                <a:spcPts val="601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cc"/>
                </a:solidFill>
                <a:latin typeface="LongIsland"/>
              </a:rPr>
              <a:t>Online patient viewing of their medical record</a:t>
            </a:r>
            <a:endParaRPr b="0" lang="en-US" sz="2400" spc="-1" strike="noStrike">
              <a:solidFill>
                <a:srgbClr val="ffffcc"/>
              </a:solidFill>
              <a:latin typeface="LongIsland"/>
            </a:endParaRPr>
          </a:p>
          <a:p>
            <a:pPr lvl="1" marL="735480" indent="-282960">
              <a:lnSpc>
                <a:spcPct val="90000"/>
              </a:lnSpc>
              <a:spcBef>
                <a:spcPts val="601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cc"/>
                </a:solidFill>
                <a:latin typeface="LongIsland"/>
              </a:rPr>
              <a:t>And more</a:t>
            </a:r>
            <a:endParaRPr b="0" lang="en-US" sz="2400" spc="-1" strike="noStrike">
              <a:solidFill>
                <a:srgbClr val="ffffcc"/>
              </a:solidFill>
              <a:latin typeface="LongIsland"/>
            </a:endParaRPr>
          </a:p>
          <a:p>
            <a:pPr marL="339480" indent="-339480">
              <a:lnSpc>
                <a:spcPct val="90000"/>
              </a:lnSpc>
              <a:spcBef>
                <a:spcPts val="700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cc"/>
                </a:solidFill>
                <a:latin typeface="LongIsland"/>
              </a:rPr>
              <a:t>May be linked to an EHR or not</a:t>
            </a: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  <a:p>
            <a:pPr lvl="1" marL="735480" indent="0">
              <a:lnSpc>
                <a:spcPct val="90000"/>
              </a:lnSpc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8080"/>
            </a:gs>
            <a:gs pos="100000">
              <a:srgbClr val="003b3b"/>
            </a:gs>
          </a:gsLst>
          <a:lin ang="135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ceHolder 1"/>
          <p:cNvSpPr>
            <a:spLocks noGrp="1"/>
          </p:cNvSpPr>
          <p:nvPr>
            <p:ph type="title"/>
          </p:nvPr>
        </p:nvSpPr>
        <p:spPr>
          <a:xfrm>
            <a:off x="169920" y="215640"/>
            <a:ext cx="8874000" cy="123804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ccecff"/>
                </a:solidFill>
                <a:latin typeface="LongIsland"/>
              </a:rPr>
              <a:t>Benefits </a:t>
            </a:r>
            <a:endParaRPr b="0" lang="en-US" sz="4400" spc="-1" strike="noStrike">
              <a:solidFill>
                <a:srgbClr val="ccecff"/>
              </a:solidFill>
              <a:latin typeface="LongIsland"/>
            </a:endParaRPr>
          </a:p>
        </p:txBody>
      </p:sp>
      <p:sp>
        <p:nvSpPr>
          <p:cNvPr id="101" name="PlaceHolder 2"/>
          <p:cNvSpPr>
            <a:spLocks noGrp="1"/>
          </p:cNvSpPr>
          <p:nvPr>
            <p:ph/>
          </p:nvPr>
        </p:nvSpPr>
        <p:spPr>
          <a:xfrm>
            <a:off x="151920" y="1828800"/>
            <a:ext cx="8837640" cy="443880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 fontScale="91000"/>
          </a:bodyPr>
          <a:p>
            <a:pPr marL="312120" indent="-312120">
              <a:lnSpc>
                <a:spcPct val="90000"/>
              </a:lnSpc>
              <a:spcBef>
                <a:spcPts val="700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 u="sng">
                <a:solidFill>
                  <a:srgbClr val="ffffcc"/>
                </a:solidFill>
                <a:uFillTx/>
                <a:latin typeface="LongIsland"/>
              </a:rPr>
              <a:t>Patient Convenience</a:t>
            </a: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  <a:p>
            <a:pPr lvl="1" marL="676080" indent="-259920">
              <a:lnSpc>
                <a:spcPct val="90000"/>
              </a:lnSpc>
              <a:spcBef>
                <a:spcPts val="499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cc"/>
                </a:solidFill>
                <a:latin typeface="LongIsland"/>
              </a:rPr>
              <a:t>Reduce phone waits and delays for patient</a:t>
            </a:r>
            <a:endParaRPr b="0" lang="en-US" sz="2000" spc="-1" strike="noStrike">
              <a:solidFill>
                <a:srgbClr val="ffffcc"/>
              </a:solidFill>
              <a:latin typeface="LongIsland"/>
            </a:endParaRPr>
          </a:p>
          <a:p>
            <a:pPr lvl="1" marL="676080" indent="-259920">
              <a:lnSpc>
                <a:spcPct val="90000"/>
              </a:lnSpc>
              <a:spcBef>
                <a:spcPts val="499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cc"/>
                </a:solidFill>
                <a:latin typeface="LongIsland"/>
              </a:rPr>
              <a:t>E-consults may allow a patient to avoid an office visit and/or missed work in some cases</a:t>
            </a:r>
            <a:endParaRPr b="0" lang="en-US" sz="2000" spc="-1" strike="noStrike">
              <a:solidFill>
                <a:srgbClr val="ffffcc"/>
              </a:solidFill>
              <a:latin typeface="LongIsland"/>
            </a:endParaRPr>
          </a:p>
          <a:p>
            <a:pPr marL="312120" indent="-312120">
              <a:lnSpc>
                <a:spcPct val="90000"/>
              </a:lnSpc>
              <a:spcBef>
                <a:spcPts val="700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 u="sng">
                <a:solidFill>
                  <a:srgbClr val="ffffcc"/>
                </a:solidFill>
                <a:uFillTx/>
                <a:latin typeface="LongIsland"/>
              </a:rPr>
              <a:t>Office Efficiency</a:t>
            </a: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  <a:p>
            <a:pPr lvl="1" marL="676080" indent="-259920">
              <a:lnSpc>
                <a:spcPct val="90000"/>
              </a:lnSpc>
              <a:spcBef>
                <a:spcPts val="499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cc"/>
                </a:solidFill>
                <a:latin typeface="LongIsland"/>
              </a:rPr>
              <a:t>May reduce phone traffic</a:t>
            </a:r>
            <a:endParaRPr b="0" lang="en-US" sz="2000" spc="-1" strike="noStrike">
              <a:solidFill>
                <a:srgbClr val="ffffcc"/>
              </a:solidFill>
              <a:latin typeface="LongIsland"/>
            </a:endParaRPr>
          </a:p>
          <a:p>
            <a:pPr lvl="1" marL="676080" indent="-259920">
              <a:lnSpc>
                <a:spcPct val="90000"/>
              </a:lnSpc>
              <a:spcBef>
                <a:spcPts val="499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cc"/>
                </a:solidFill>
                <a:latin typeface="LongIsland"/>
              </a:rPr>
              <a:t>Eliminates phone tag</a:t>
            </a:r>
            <a:endParaRPr b="0" lang="en-US" sz="2000" spc="-1" strike="noStrike">
              <a:solidFill>
                <a:srgbClr val="ffffcc"/>
              </a:solidFill>
              <a:latin typeface="LongIsland"/>
            </a:endParaRPr>
          </a:p>
          <a:p>
            <a:pPr lvl="1" marL="676080" indent="-259920">
              <a:lnSpc>
                <a:spcPct val="90000"/>
              </a:lnSpc>
              <a:spcBef>
                <a:spcPts val="499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cc"/>
                </a:solidFill>
                <a:latin typeface="LongIsland"/>
              </a:rPr>
              <a:t>Patient documents their own message</a:t>
            </a:r>
            <a:endParaRPr b="0" lang="en-US" sz="2000" spc="-1" strike="noStrike">
              <a:solidFill>
                <a:srgbClr val="ffffcc"/>
              </a:solidFill>
              <a:latin typeface="LongIsland"/>
            </a:endParaRPr>
          </a:p>
          <a:p>
            <a:pPr marL="312120" indent="-312120">
              <a:lnSpc>
                <a:spcPct val="90000"/>
              </a:lnSpc>
              <a:spcBef>
                <a:spcPts val="700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 u="sng">
                <a:solidFill>
                  <a:srgbClr val="ffffcc"/>
                </a:solidFill>
                <a:uFillTx/>
                <a:latin typeface="LongIsland"/>
              </a:rPr>
              <a:t>Patient-Physician Communication</a:t>
            </a: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  <a:p>
            <a:pPr lvl="1" marL="676080" indent="-259920">
              <a:lnSpc>
                <a:spcPct val="90000"/>
              </a:lnSpc>
              <a:spcBef>
                <a:spcPts val="499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cc"/>
                </a:solidFill>
                <a:latin typeface="LongIsland"/>
              </a:rPr>
              <a:t>Direct communication with no “middle man”</a:t>
            </a:r>
            <a:endParaRPr b="0" lang="en-US" sz="2000" spc="-1" strike="noStrike">
              <a:solidFill>
                <a:srgbClr val="ffffcc"/>
              </a:solidFill>
              <a:latin typeface="LongIsland"/>
            </a:endParaRPr>
          </a:p>
          <a:p>
            <a:pPr marL="312120" indent="-312120">
              <a:lnSpc>
                <a:spcPct val="90000"/>
              </a:lnSpc>
              <a:spcBef>
                <a:spcPts val="700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 u="sng">
                <a:solidFill>
                  <a:srgbClr val="ffffcc"/>
                </a:solidFill>
                <a:uFillTx/>
                <a:latin typeface="LongIsland"/>
              </a:rPr>
              <a:t>Revenue source ???</a:t>
            </a: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  <a:p>
            <a:pPr lvl="1" marL="676080" indent="-259920">
              <a:lnSpc>
                <a:spcPct val="90000"/>
              </a:lnSpc>
              <a:spcBef>
                <a:spcPts val="499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cc"/>
                </a:solidFill>
                <a:latin typeface="LongIsland"/>
              </a:rPr>
              <a:t>Source of net income for physicians? </a:t>
            </a:r>
            <a:endParaRPr b="0" lang="en-US" sz="2000" spc="-1" strike="noStrike">
              <a:solidFill>
                <a:srgbClr val="ffffcc"/>
              </a:solidFill>
              <a:latin typeface="LongIsland"/>
            </a:endParaRPr>
          </a:p>
          <a:p>
            <a:pPr lvl="1" marL="676080" indent="-259920">
              <a:lnSpc>
                <a:spcPct val="90000"/>
              </a:lnSpc>
              <a:spcBef>
                <a:spcPts val="499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cc"/>
                </a:solidFill>
                <a:latin typeface="LongIsland"/>
              </a:rPr>
              <a:t>Will patients pay for this?</a:t>
            </a:r>
            <a:endParaRPr b="0" lang="en-US" sz="2000" spc="-1" strike="noStrike">
              <a:solidFill>
                <a:srgbClr val="ffffcc"/>
              </a:solidFill>
              <a:latin typeface="LongIsland"/>
            </a:endParaRPr>
          </a:p>
          <a:p>
            <a:pPr lvl="1" marL="676080" indent="0">
              <a:lnSpc>
                <a:spcPct val="90000"/>
              </a:lnSpc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ffffcc"/>
              </a:solidFill>
              <a:latin typeface="LongIsland"/>
            </a:endParaRPr>
          </a:p>
          <a:p>
            <a:pPr marL="312120" indent="0">
              <a:lnSpc>
                <a:spcPct val="90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ffffcc"/>
              </a:solidFill>
              <a:latin typeface="LongIsland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8080"/>
            </a:gs>
            <a:gs pos="100000">
              <a:srgbClr val="003b3b"/>
            </a:gs>
          </a:gsLst>
          <a:lin ang="135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PlaceHolder 1"/>
          <p:cNvSpPr>
            <a:spLocks noGrp="1"/>
          </p:cNvSpPr>
          <p:nvPr>
            <p:ph type="title"/>
          </p:nvPr>
        </p:nvSpPr>
        <p:spPr>
          <a:xfrm>
            <a:off x="169920" y="215640"/>
            <a:ext cx="8874000" cy="123804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ccecff"/>
                </a:solidFill>
                <a:latin typeface="LongIsland"/>
              </a:rPr>
              <a:t>Barriers to implementation:</a:t>
            </a:r>
            <a:br>
              <a:rPr sz="4400"/>
            </a:br>
            <a:r>
              <a:rPr b="0" lang="en-US" sz="3200" spc="-1" strike="noStrike">
                <a:solidFill>
                  <a:srgbClr val="ccecff"/>
                </a:solidFill>
                <a:latin typeface="LongIsland"/>
              </a:rPr>
              <a:t>or why doesn’t every doctor offer one?</a:t>
            </a:r>
            <a:endParaRPr b="0" lang="en-US" sz="3200" spc="-1" strike="noStrike">
              <a:solidFill>
                <a:srgbClr val="ccecff"/>
              </a:solidFill>
              <a:latin typeface="LongIsland"/>
            </a:endParaRPr>
          </a:p>
        </p:txBody>
      </p:sp>
      <p:sp>
        <p:nvSpPr>
          <p:cNvPr id="103" name="PlaceHolder 2"/>
          <p:cNvSpPr>
            <a:spLocks noGrp="1"/>
          </p:cNvSpPr>
          <p:nvPr>
            <p:ph/>
          </p:nvPr>
        </p:nvSpPr>
        <p:spPr>
          <a:xfrm>
            <a:off x="182160" y="1801800"/>
            <a:ext cx="8837640" cy="443880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marL="343080" indent="-343080">
              <a:lnSpc>
                <a:spcPct val="90000"/>
              </a:lnSpc>
              <a:spcBef>
                <a:spcPts val="799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cc"/>
                </a:solidFill>
                <a:latin typeface="LongIsland"/>
              </a:rPr>
              <a:t>Concerns about privacy and confidentiality</a:t>
            </a: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  <a:p>
            <a:pPr marL="343080" indent="0">
              <a:lnSpc>
                <a:spcPct val="60000"/>
              </a:lnSpc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  <a:p>
            <a:pPr marL="343080" indent="-343080">
              <a:lnSpc>
                <a:spcPct val="60000"/>
              </a:lnSpc>
              <a:spcBef>
                <a:spcPts val="799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cc"/>
                </a:solidFill>
                <a:latin typeface="LongIsland"/>
              </a:rPr>
              <a:t>Physician medicolegal concerns</a:t>
            </a: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  <a:p>
            <a:pPr marL="343080" indent="0">
              <a:lnSpc>
                <a:spcPct val="60000"/>
              </a:lnSpc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  <a:p>
            <a:pPr marL="343080" indent="-343080">
              <a:lnSpc>
                <a:spcPct val="60000"/>
              </a:lnSpc>
              <a:spcBef>
                <a:spcPts val="799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cc"/>
                </a:solidFill>
                <a:latin typeface="LongIsland"/>
              </a:rPr>
              <a:t>Practical workflow concerns</a:t>
            </a: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  <a:p>
            <a:pPr marL="343080" indent="0">
              <a:lnSpc>
                <a:spcPct val="60000"/>
              </a:lnSpc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  <a:p>
            <a:pPr marL="343080" indent="-343080">
              <a:lnSpc>
                <a:spcPct val="90000"/>
              </a:lnSpc>
              <a:spcBef>
                <a:spcPts val="799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cc"/>
                </a:solidFill>
                <a:latin typeface="LongIsland"/>
              </a:rPr>
              <a:t>Physician fear of being overwhelmed by patient messages</a:t>
            </a: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  <a:p>
            <a:pPr marL="343080" indent="0">
              <a:lnSpc>
                <a:spcPct val="60000"/>
              </a:lnSpc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  <a:p>
            <a:pPr marL="343080" indent="-343080">
              <a:lnSpc>
                <a:spcPct val="60000"/>
              </a:lnSpc>
              <a:spcBef>
                <a:spcPts val="799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cc"/>
                </a:solidFill>
                <a:latin typeface="LongIsland"/>
              </a:rPr>
              <a:t>Lack of reimbursement</a:t>
            </a: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  <a:p>
            <a:pPr marL="343080"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8080"/>
            </a:gs>
            <a:gs pos="100000">
              <a:srgbClr val="003b3b"/>
            </a:gs>
          </a:gsLst>
          <a:lin ang="135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title"/>
          </p:nvPr>
        </p:nvSpPr>
        <p:spPr>
          <a:xfrm>
            <a:off x="169920" y="215640"/>
            <a:ext cx="8874000" cy="123804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ccecff"/>
                </a:solidFill>
                <a:latin typeface="LongIsland"/>
              </a:rPr>
              <a:t>Who’s online and who wants their doctor to be online too ?</a:t>
            </a:r>
            <a:endParaRPr b="0" lang="en-US" sz="4400" spc="-1" strike="noStrike">
              <a:solidFill>
                <a:srgbClr val="ccecff"/>
              </a:solidFill>
              <a:latin typeface="LongIsland"/>
            </a:endParaRPr>
          </a:p>
        </p:txBody>
      </p:sp>
      <p:sp>
        <p:nvSpPr>
          <p:cNvPr id="105" name="PlaceHolder 2"/>
          <p:cNvSpPr>
            <a:spLocks noGrp="1"/>
          </p:cNvSpPr>
          <p:nvPr>
            <p:ph/>
          </p:nvPr>
        </p:nvSpPr>
        <p:spPr>
          <a:xfrm>
            <a:off x="182160" y="1801800"/>
            <a:ext cx="8837640" cy="482760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/>
          </a:bodyPr>
          <a:p>
            <a:pPr marL="343080" indent="-343080">
              <a:lnSpc>
                <a:spcPct val="125000"/>
              </a:lnSpc>
              <a:spcBef>
                <a:spcPts val="799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cc"/>
                </a:solidFill>
                <a:latin typeface="LongIsland"/>
              </a:rPr>
              <a:t>77% of US adults online</a:t>
            </a: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  <a:p>
            <a:pPr lvl="1" marL="743040" indent="-285840">
              <a:lnSpc>
                <a:spcPct val="125000"/>
              </a:lnSpc>
              <a:spcBef>
                <a:spcPts val="601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cc"/>
                </a:solidFill>
                <a:latin typeface="LongIsland"/>
              </a:rPr>
              <a:t>Harris Interactive phone survey - May 2006</a:t>
            </a:r>
            <a:r>
              <a:rPr b="0" lang="en-US" sz="2400" spc="-1" strike="noStrike">
                <a:solidFill>
                  <a:srgbClr val="ffffcc"/>
                </a:solidFill>
                <a:latin typeface="LongIsland"/>
              </a:rPr>
              <a:t> </a:t>
            </a:r>
            <a:endParaRPr b="0" lang="en-US" sz="2400" spc="-1" strike="noStrike">
              <a:solidFill>
                <a:srgbClr val="ffffcc"/>
              </a:solidFill>
              <a:latin typeface="LongIsland"/>
            </a:endParaRPr>
          </a:p>
          <a:p>
            <a:pPr marL="343080" indent="-343080">
              <a:lnSpc>
                <a:spcPct val="125000"/>
              </a:lnSpc>
              <a:spcBef>
                <a:spcPts val="799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cc"/>
                </a:solidFill>
                <a:latin typeface="LongIsland"/>
              </a:rPr>
              <a:t>90% of online adults would like to communicate with their physicians online</a:t>
            </a: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  <a:p>
            <a:pPr lvl="1" marL="743040" indent="-285840">
              <a:lnSpc>
                <a:spcPct val="125000"/>
              </a:lnSpc>
              <a:spcBef>
                <a:spcPts val="499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cc"/>
                </a:solidFill>
                <a:latin typeface="LongIsland"/>
              </a:rPr>
              <a:t>Harris Interactive survey - 2002</a:t>
            </a:r>
            <a:endParaRPr b="0" lang="en-US" sz="2000" spc="-1" strike="noStrike">
              <a:solidFill>
                <a:srgbClr val="ffffcc"/>
              </a:solidFill>
              <a:latin typeface="LongIsland"/>
            </a:endParaRPr>
          </a:p>
          <a:p>
            <a:pPr marL="343080" indent="-343080">
              <a:lnSpc>
                <a:spcPct val="125000"/>
              </a:lnSpc>
              <a:spcBef>
                <a:spcPts val="799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cc"/>
                </a:solidFill>
                <a:latin typeface="LongIsland"/>
              </a:rPr>
              <a:t>Web portal patients had higher satisfaction with physician-patient communication</a:t>
            </a: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  <a:p>
            <a:pPr lvl="1" marL="743040" indent="-285840">
              <a:lnSpc>
                <a:spcPct val="125000"/>
              </a:lnSpc>
              <a:spcBef>
                <a:spcPts val="499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cc"/>
                </a:solidFill>
                <a:latin typeface="LongIsland"/>
              </a:rPr>
              <a:t>Randomized controlled trial – Lin et al - 2005</a:t>
            </a:r>
            <a:endParaRPr b="0" lang="en-US" sz="2000" spc="-1" strike="noStrike">
              <a:solidFill>
                <a:srgbClr val="ffffcc"/>
              </a:solidFill>
              <a:latin typeface="LongIsland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8080"/>
            </a:gs>
            <a:gs pos="100000">
              <a:srgbClr val="003b3b"/>
            </a:gs>
          </a:gsLst>
          <a:lin ang="135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PlaceHolder 1"/>
          <p:cNvSpPr>
            <a:spLocks noGrp="1"/>
          </p:cNvSpPr>
          <p:nvPr>
            <p:ph type="title"/>
          </p:nvPr>
        </p:nvSpPr>
        <p:spPr>
          <a:xfrm>
            <a:off x="169920" y="215640"/>
            <a:ext cx="8874000" cy="123804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ccecff"/>
                </a:solidFill>
                <a:latin typeface="LongIsland"/>
              </a:rPr>
              <a:t>Patients want it, but will they pay for it?</a:t>
            </a:r>
            <a:endParaRPr b="0" lang="en-US" sz="3600" spc="-1" strike="noStrike">
              <a:solidFill>
                <a:srgbClr val="ccecff"/>
              </a:solidFill>
              <a:latin typeface="LongIsland"/>
            </a:endParaRPr>
          </a:p>
        </p:txBody>
      </p:sp>
      <p:sp>
        <p:nvSpPr>
          <p:cNvPr id="107" name="PlaceHolder 2"/>
          <p:cNvSpPr>
            <a:spLocks noGrp="1"/>
          </p:cNvSpPr>
          <p:nvPr>
            <p:ph/>
          </p:nvPr>
        </p:nvSpPr>
        <p:spPr>
          <a:xfrm>
            <a:off x="182160" y="1981080"/>
            <a:ext cx="8837640" cy="464832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 fontScale="96000"/>
          </a:bodyPr>
          <a:p>
            <a:pPr marL="329040" indent="-329040">
              <a:lnSpc>
                <a:spcPct val="90000"/>
              </a:lnSpc>
              <a:spcBef>
                <a:spcPts val="799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cc"/>
                </a:solidFill>
                <a:latin typeface="LongIsland"/>
              </a:rPr>
              <a:t>2002 Harris Interactive survey </a:t>
            </a: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  <a:p>
            <a:pPr lvl="1" marL="713160" indent="-274320">
              <a:lnSpc>
                <a:spcPct val="90000"/>
              </a:lnSpc>
              <a:spcBef>
                <a:spcPts val="601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cc"/>
                </a:solidFill>
                <a:latin typeface="LongIsland"/>
              </a:rPr>
              <a:t>37%</a:t>
            </a:r>
            <a:r>
              <a:rPr b="0" lang="en-US" sz="2400" spc="-1" strike="noStrike">
                <a:solidFill>
                  <a:srgbClr val="ffffcc"/>
                </a:solidFill>
                <a:latin typeface="LongIsland"/>
              </a:rPr>
              <a:t> willing to pay for email with physicians</a:t>
            </a:r>
            <a:endParaRPr b="0" lang="en-US" sz="2400" spc="-1" strike="noStrike">
              <a:solidFill>
                <a:srgbClr val="ffffcc"/>
              </a:solidFill>
              <a:latin typeface="LongIsland"/>
            </a:endParaRPr>
          </a:p>
          <a:p>
            <a:pPr marL="329040" indent="-329040">
              <a:lnSpc>
                <a:spcPct val="90000"/>
              </a:lnSpc>
              <a:spcBef>
                <a:spcPts val="799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cc"/>
                </a:solidFill>
                <a:latin typeface="LongIsland"/>
              </a:rPr>
              <a:t>2005 Harris Interactive survey</a:t>
            </a: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  <a:p>
            <a:pPr lvl="1" marL="713160" indent="-274320">
              <a:lnSpc>
                <a:spcPct val="90000"/>
              </a:lnSpc>
              <a:spcBef>
                <a:spcPts val="601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cc"/>
                </a:solidFill>
                <a:latin typeface="LongIsland"/>
              </a:rPr>
              <a:t>36%</a:t>
            </a:r>
            <a:r>
              <a:rPr b="0" lang="en-US" sz="2400" spc="-1" strike="noStrike">
                <a:solidFill>
                  <a:srgbClr val="ffffcc"/>
                </a:solidFill>
                <a:latin typeface="LongIsland"/>
              </a:rPr>
              <a:t> willing to pay for email with physicians</a:t>
            </a:r>
            <a:endParaRPr b="0" lang="en-US" sz="2400" spc="-1" strike="noStrike">
              <a:solidFill>
                <a:srgbClr val="ffffcc"/>
              </a:solidFill>
              <a:latin typeface="LongIsland"/>
            </a:endParaRPr>
          </a:p>
          <a:p>
            <a:pPr marL="329040" indent="-329040">
              <a:lnSpc>
                <a:spcPct val="90000"/>
              </a:lnSpc>
              <a:spcBef>
                <a:spcPts val="799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cc"/>
                </a:solidFill>
                <a:latin typeface="LongIsland"/>
              </a:rPr>
              <a:t>2005 study by Lin et al</a:t>
            </a: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  <a:p>
            <a:pPr lvl="1" marL="713160" indent="-274320">
              <a:lnSpc>
                <a:spcPct val="90000"/>
              </a:lnSpc>
              <a:spcBef>
                <a:spcPts val="601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cc"/>
                </a:solidFill>
                <a:latin typeface="LongIsland"/>
              </a:rPr>
              <a:t>48%</a:t>
            </a:r>
            <a:r>
              <a:rPr b="0" lang="en-US" sz="2400" spc="-1" strike="noStrike">
                <a:solidFill>
                  <a:srgbClr val="ffffcc"/>
                </a:solidFill>
                <a:latin typeface="LongIsland"/>
              </a:rPr>
              <a:t> willing to pay for online correspondence with academic internal medicine practice in CO</a:t>
            </a:r>
            <a:endParaRPr b="0" lang="en-US" sz="2400" spc="-1" strike="noStrike">
              <a:solidFill>
                <a:srgbClr val="ffffcc"/>
              </a:solidFill>
              <a:latin typeface="LongIsland"/>
            </a:endParaRPr>
          </a:p>
          <a:p>
            <a:pPr marL="329040" indent="-329040">
              <a:lnSpc>
                <a:spcPct val="90000"/>
              </a:lnSpc>
              <a:spcBef>
                <a:spcPts val="901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ffffcc"/>
                </a:solidFill>
                <a:latin typeface="LongIsland"/>
              </a:rPr>
              <a:t>Summary:  prior reports suggested that </a:t>
            </a:r>
            <a:endParaRPr b="0" lang="en-US" sz="3600" spc="-1" strike="noStrike">
              <a:solidFill>
                <a:srgbClr val="ffffcc"/>
              </a:solidFill>
              <a:latin typeface="LongIsland"/>
            </a:endParaRPr>
          </a:p>
          <a:p>
            <a:pPr marL="32904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ffffcc"/>
                </a:solidFill>
                <a:latin typeface="LongIsland"/>
              </a:rPr>
              <a:t>                     </a:t>
            </a:r>
            <a:r>
              <a:rPr b="0" lang="en-US" sz="3600" spc="-1" strike="noStrike">
                <a:solidFill>
                  <a:srgbClr val="ffffcc"/>
                </a:solidFill>
                <a:latin typeface="LongIsland"/>
              </a:rPr>
              <a:t>&lt; 50% willing to pay for it</a:t>
            </a:r>
            <a:endParaRPr b="0" lang="en-US" sz="3600" spc="-1" strike="noStrike">
              <a:solidFill>
                <a:srgbClr val="ffffcc"/>
              </a:solidFill>
              <a:latin typeface="LongIsland"/>
            </a:endParaRPr>
          </a:p>
          <a:p>
            <a:pPr lvl="1" marL="71316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ffffcc"/>
              </a:solidFill>
              <a:latin typeface="LongIsland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8080"/>
            </a:gs>
            <a:gs pos="100000">
              <a:srgbClr val="003b3b"/>
            </a:gs>
          </a:gsLst>
          <a:lin ang="135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169920" y="215640"/>
            <a:ext cx="8874000" cy="123804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ccecff"/>
                </a:solidFill>
                <a:latin typeface="LongIsland"/>
              </a:rPr>
              <a:t>Some encouraging news</a:t>
            </a:r>
            <a:endParaRPr b="0" lang="en-US" sz="4400" spc="-1" strike="noStrike">
              <a:solidFill>
                <a:srgbClr val="ccecff"/>
              </a:solidFill>
              <a:latin typeface="LongIsland"/>
            </a:endParaRPr>
          </a:p>
        </p:txBody>
      </p:sp>
      <p:sp>
        <p:nvSpPr>
          <p:cNvPr id="109" name="PlaceHolder 2"/>
          <p:cNvSpPr>
            <a:spLocks noGrp="1"/>
          </p:cNvSpPr>
          <p:nvPr>
            <p:ph/>
          </p:nvPr>
        </p:nvSpPr>
        <p:spPr>
          <a:xfrm>
            <a:off x="182160" y="1801800"/>
            <a:ext cx="8837640" cy="443880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 fontScale="88000"/>
          </a:bodyPr>
          <a:p>
            <a:pPr marL="301680" indent="-301680">
              <a:lnSpc>
                <a:spcPct val="130000"/>
              </a:lnSpc>
              <a:spcBef>
                <a:spcPts val="799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cc"/>
                </a:solidFill>
                <a:latin typeface="LongIsland"/>
              </a:rPr>
              <a:t>“</a:t>
            </a:r>
            <a:r>
              <a:rPr b="0" i="1" lang="en-US" sz="3200" spc="-1" strike="noStrike">
                <a:solidFill>
                  <a:srgbClr val="ffffcc"/>
                </a:solidFill>
                <a:latin typeface="LongIsland"/>
              </a:rPr>
              <a:t>Web Portals in Primary Care:                              An Evaluation of Patient Readiness and Willingness to Pay for Online Services”</a:t>
            </a:r>
            <a:endParaRPr b="0" lang="en-US" sz="3200" spc="-1" strike="noStrike">
              <a:solidFill>
                <a:srgbClr val="ffffcc"/>
              </a:solidFill>
              <a:latin typeface="LongIsland"/>
            </a:endParaRPr>
          </a:p>
          <a:p>
            <a:pPr marL="301680" indent="-301680">
              <a:lnSpc>
                <a:spcPct val="130000"/>
              </a:lnSpc>
              <a:spcBef>
                <a:spcPts val="601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cc"/>
                </a:solidFill>
                <a:latin typeface="LongIsland"/>
              </a:rPr>
              <a:t>Author:  </a:t>
            </a:r>
            <a:r>
              <a:rPr b="0" lang="en-US" sz="2400" spc="-1" strike="noStrike">
                <a:solidFill>
                  <a:srgbClr val="ffffcc"/>
                </a:solidFill>
                <a:latin typeface="LongIsland"/>
              </a:rPr>
              <a:t>Kenneth Adler, MD, MMM</a:t>
            </a:r>
            <a:endParaRPr b="0" lang="en-US" sz="2400" spc="-1" strike="noStrike">
              <a:solidFill>
                <a:srgbClr val="ffffcc"/>
              </a:solidFill>
              <a:latin typeface="LongIsland"/>
            </a:endParaRPr>
          </a:p>
          <a:p>
            <a:pPr marL="301680" indent="-301680">
              <a:lnSpc>
                <a:spcPct val="130000"/>
              </a:lnSpc>
              <a:spcBef>
                <a:spcPts val="700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cc"/>
                </a:solidFill>
                <a:latin typeface="LongIsland"/>
              </a:rPr>
              <a:t>Journal: </a:t>
            </a: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  <a:p>
            <a:pPr lvl="1" marL="653760" indent="-251280">
              <a:lnSpc>
                <a:spcPct val="130000"/>
              </a:lnSpc>
              <a:spcBef>
                <a:spcPts val="601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cc"/>
                </a:solidFill>
                <a:latin typeface="LongIsland"/>
              </a:rPr>
              <a:t>Journal of Medical Internet Research</a:t>
            </a:r>
            <a:endParaRPr b="0" lang="en-US" sz="2400" spc="-1" strike="noStrike">
              <a:solidFill>
                <a:srgbClr val="ffffcc"/>
              </a:solidFill>
              <a:latin typeface="LongIsland"/>
            </a:endParaRPr>
          </a:p>
          <a:p>
            <a:pPr lvl="1" marL="653760" indent="-251280">
              <a:lnSpc>
                <a:spcPct val="130000"/>
              </a:lnSpc>
              <a:spcBef>
                <a:spcPts val="601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cc"/>
                </a:solidFill>
                <a:latin typeface="LongIsland"/>
              </a:rPr>
              <a:t>Volume 8,  Issue 4  (October 2006)</a:t>
            </a:r>
            <a:endParaRPr b="0" lang="en-US" sz="2400" spc="-1" strike="noStrike">
              <a:solidFill>
                <a:srgbClr val="ffffcc"/>
              </a:solidFill>
              <a:latin typeface="LongIsland"/>
            </a:endParaRPr>
          </a:p>
          <a:p>
            <a:pPr lvl="1" marL="653760" indent="-251280">
              <a:lnSpc>
                <a:spcPct val="130000"/>
              </a:lnSpc>
              <a:spcBef>
                <a:spcPts val="601"/>
              </a:spcBef>
              <a:buClr>
                <a:srgbClr val="b2b2b2"/>
              </a:buClr>
              <a:buSzPct val="7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 u="sng">
                <a:solidFill>
                  <a:srgbClr val="cc00cc"/>
                </a:solidFill>
                <a:uFillTx/>
                <a:latin typeface="LongIsland"/>
                <a:hlinkClick r:id="rId1"/>
              </a:rPr>
              <a:t>www.jmir.org/2006</a:t>
            </a:r>
            <a:r>
              <a:rPr b="0" lang="en-US" sz="2400" spc="-1" strike="noStrike">
                <a:solidFill>
                  <a:srgbClr val="ffffcc"/>
                </a:solidFill>
                <a:latin typeface="LongIsland"/>
              </a:rPr>
              <a:t> </a:t>
            </a:r>
            <a:endParaRPr b="0" lang="en-US" sz="2400" spc="-1" strike="noStrike">
              <a:solidFill>
                <a:srgbClr val="ffffcc"/>
              </a:solidFill>
              <a:latin typeface="LongIsland"/>
            </a:endParaRPr>
          </a:p>
          <a:p>
            <a:pPr lvl="1" marL="653760" indent="0">
              <a:lnSpc>
                <a:spcPct val="90000"/>
              </a:lnSpc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cc"/>
              </a:solidFill>
              <a:latin typeface="LongIsland"/>
            </a:endParaRPr>
          </a:p>
          <a:p>
            <a:pPr lvl="1" marL="653760" indent="0">
              <a:lnSpc>
                <a:spcPct val="90000"/>
              </a:lnSpc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ffffcc"/>
              </a:solidFill>
              <a:latin typeface="LongIsland"/>
            </a:endParaRPr>
          </a:p>
          <a:p>
            <a:pPr lvl="1" marL="653760" indent="0">
              <a:lnSpc>
                <a:spcPct val="90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ffffcc"/>
              </a:solidFill>
              <a:latin typeface="LongIsland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8080"/>
            </a:gs>
            <a:gs pos="100000">
              <a:srgbClr val="003b3b"/>
            </a:gs>
          </a:gsLst>
          <a:lin ang="135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PlaceHolder 1"/>
          <p:cNvSpPr>
            <a:spLocks noGrp="1"/>
          </p:cNvSpPr>
          <p:nvPr>
            <p:ph type="title"/>
          </p:nvPr>
        </p:nvSpPr>
        <p:spPr>
          <a:xfrm>
            <a:off x="169920" y="215640"/>
            <a:ext cx="8874000" cy="123804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ccecff"/>
                </a:solidFill>
                <a:latin typeface="LongIsland"/>
              </a:rPr>
              <a:t>Study Objectives</a:t>
            </a:r>
            <a:endParaRPr b="0" lang="en-US" sz="4400" spc="-1" strike="noStrike">
              <a:solidFill>
                <a:srgbClr val="ccecff"/>
              </a:solidFill>
              <a:latin typeface="LongIsland"/>
            </a:endParaRPr>
          </a:p>
        </p:txBody>
      </p:sp>
      <p:sp>
        <p:nvSpPr>
          <p:cNvPr id="111" name="PlaceHolder 2"/>
          <p:cNvSpPr>
            <a:spLocks noGrp="1"/>
          </p:cNvSpPr>
          <p:nvPr>
            <p:ph/>
          </p:nvPr>
        </p:nvSpPr>
        <p:spPr>
          <a:xfrm>
            <a:off x="182160" y="1981080"/>
            <a:ext cx="8837640" cy="464832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rmAutofit fontScale="97000"/>
          </a:bodyPr>
          <a:p>
            <a:pPr marL="332640" indent="-332640">
              <a:lnSpc>
                <a:spcPct val="90000"/>
              </a:lnSpc>
              <a:spcBef>
                <a:spcPts val="700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cc"/>
                </a:solidFill>
                <a:latin typeface="LongIsland"/>
              </a:rPr>
              <a:t>Learn the true level of demand for online services in a fairly typical urban family medicine practice </a:t>
            </a: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  <a:p>
            <a:pPr marL="332640" indent="0">
              <a:lnSpc>
                <a:spcPct val="90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  <a:p>
            <a:pPr marL="332640" indent="-332640">
              <a:lnSpc>
                <a:spcPct val="90000"/>
              </a:lnSpc>
              <a:spcBef>
                <a:spcPts val="700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cc"/>
                </a:solidFill>
                <a:latin typeface="LongIsland"/>
              </a:rPr>
              <a:t>Determine levels of patient Internet access </a:t>
            </a: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  <a:p>
            <a:pPr marL="332640" indent="0">
              <a:lnSpc>
                <a:spcPct val="90000"/>
              </a:lnSpc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cc"/>
                </a:solidFill>
                <a:latin typeface="LongIsland"/>
              </a:rPr>
              <a:t>   </a:t>
            </a:r>
            <a:r>
              <a:rPr b="0" lang="en-US" sz="2800" spc="-1" strike="noStrike">
                <a:solidFill>
                  <a:srgbClr val="ffffcc"/>
                </a:solidFill>
                <a:latin typeface="LongIsland"/>
              </a:rPr>
              <a:t>by age, sex, employment, and overall</a:t>
            </a: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  <a:p>
            <a:pPr marL="332640" indent="0">
              <a:lnSpc>
                <a:spcPct val="90000"/>
              </a:lnSpc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  <a:p>
            <a:pPr marL="332640" indent="-332640">
              <a:lnSpc>
                <a:spcPct val="90000"/>
              </a:lnSpc>
              <a:spcBef>
                <a:spcPts val="700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cc"/>
                </a:solidFill>
                <a:latin typeface="LongIsland"/>
              </a:rPr>
              <a:t>Identify willingness to pay for online services based on patient demographics and overall</a:t>
            </a: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  <a:p>
            <a:pPr marL="332640" indent="0">
              <a:lnSpc>
                <a:spcPct val="90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  <a:p>
            <a:pPr marL="332640" indent="-332640">
              <a:lnSpc>
                <a:spcPct val="90000"/>
              </a:lnSpc>
              <a:spcBef>
                <a:spcPts val="700"/>
              </a:spcBef>
              <a:buClr>
                <a:srgbClr val="cc00cc"/>
              </a:buClr>
              <a:buSzPct val="75000"/>
              <a:buFont typeface="Wingdings" charset="2"/>
              <a:buChar char="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cc"/>
                </a:solidFill>
                <a:latin typeface="LongIsland"/>
              </a:rPr>
              <a:t>Discover which online services patients value most</a:t>
            </a:r>
            <a:endParaRPr b="0" lang="en-US" sz="2800" spc="-1" strike="noStrike">
              <a:solidFill>
                <a:srgbClr val="ffffcc"/>
              </a:solidFill>
              <a:latin typeface="LongIsland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8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0-15T16:43:42Z</dcterms:created>
  <dc:creator>Kenneth Adler</dc:creator>
  <dc:description/>
  <dc:language>en-US</dc:language>
  <cp:lastModifiedBy>Kenneth Adler</cp:lastModifiedBy>
  <dcterms:modified xsi:type="dcterms:W3CDTF">2006-10-21T19:41:10Z</dcterms:modified>
  <cp:revision>22</cp:revision>
  <dc:subject/>
  <dc:title> Patient Web Portals: 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